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24"/>
  </p:handoutMasterIdLst>
  <p:sldIdLst>
    <p:sldId id="313" r:id="rId2"/>
    <p:sldId id="294" r:id="rId3"/>
    <p:sldId id="321" r:id="rId4"/>
    <p:sldId id="322" r:id="rId5"/>
    <p:sldId id="296" r:id="rId6"/>
    <p:sldId id="314" r:id="rId7"/>
    <p:sldId id="325" r:id="rId8"/>
    <p:sldId id="315" r:id="rId9"/>
    <p:sldId id="316" r:id="rId10"/>
    <p:sldId id="317" r:id="rId11"/>
    <p:sldId id="324" r:id="rId12"/>
    <p:sldId id="298" r:id="rId13"/>
    <p:sldId id="326" r:id="rId14"/>
    <p:sldId id="318" r:id="rId15"/>
    <p:sldId id="299" r:id="rId16"/>
    <p:sldId id="303" r:id="rId17"/>
    <p:sldId id="304" r:id="rId18"/>
    <p:sldId id="319" r:id="rId19"/>
    <p:sldId id="305" r:id="rId20"/>
    <p:sldId id="300" r:id="rId21"/>
    <p:sldId id="320" r:id="rId22"/>
    <p:sldId id="306" r:id="rId23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hierry Gaude" initials="MOU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4DE"/>
    <a:srgbClr val="33CC33"/>
    <a:srgbClr val="0000FF"/>
    <a:srgbClr val="09ADFF"/>
    <a:srgbClr val="43C0FF"/>
    <a:srgbClr val="0066FF"/>
    <a:srgbClr val="66CCFF"/>
    <a:srgbClr val="008000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83" autoAdjust="0"/>
    <p:restoredTop sz="99396" autoAdjust="0"/>
  </p:normalViewPr>
  <p:slideViewPr>
    <p:cSldViewPr>
      <p:cViewPr>
        <p:scale>
          <a:sx n="120" d="100"/>
          <a:sy n="120" d="100"/>
        </p:scale>
        <p:origin x="-2334" y="-72"/>
      </p:cViewPr>
      <p:guideLst>
        <p:guide orient="horz" pos="1292"/>
        <p:guide pos="40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sabelle\backup$\Manip\pollinisations\pollinisation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ilexe-Article%20FR-230119\selection%20transgeniques\anciennes%20donn&#233;es-100119\QPCR%20SRK%20AC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silexe\SICE\pollination%20Group\fr&#233;d&#233;rique\Article\figure%201\aniline%20blu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D50-254A-B775-74867D1158D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D50-254A-B775-74867D1158D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D50-254A-B775-74867D1158D6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D50-254A-B775-74867D1158D6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D50-254A-B775-74867D1158D6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D50-254A-B775-74867D1158D6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D50-254A-B775-74867D1158D6}"/>
              </c:ext>
            </c:extLst>
          </c:dPt>
          <c:errBars>
            <c:errBarType val="plus"/>
            <c:errValType val="cust"/>
            <c:noEndCap val="0"/>
            <c:plus>
              <c:numRef>
                <c:f>AlSRK14!$O$17:$O$24</c:f>
                <c:numCache>
                  <c:formatCode>General</c:formatCode>
                  <c:ptCount val="8"/>
                  <c:pt idx="0">
                    <c:v>0.3</c:v>
                  </c:pt>
                  <c:pt idx="1">
                    <c:v>0</c:v>
                  </c:pt>
                  <c:pt idx="2">
                    <c:v>1.8</c:v>
                  </c:pt>
                  <c:pt idx="3">
                    <c:v>0.3</c:v>
                  </c:pt>
                  <c:pt idx="4">
                    <c:v>0</c:v>
                  </c:pt>
                  <c:pt idx="5">
                    <c:v>1.1086778913041726</c:v>
                  </c:pt>
                  <c:pt idx="6">
                    <c:v>1.6</c:v>
                  </c:pt>
                  <c:pt idx="7">
                    <c:v>0</c:v>
                  </c:pt>
                </c:numCache>
              </c:numRef>
            </c:plus>
            <c:minus>
              <c:numRef>
                <c:f>AlSRK14!$O$17:$O$24</c:f>
                <c:numCache>
                  <c:formatCode>General</c:formatCode>
                  <c:ptCount val="8"/>
                  <c:pt idx="0">
                    <c:v>0.3</c:v>
                  </c:pt>
                  <c:pt idx="1">
                    <c:v>0</c:v>
                  </c:pt>
                  <c:pt idx="2">
                    <c:v>1.8</c:v>
                  </c:pt>
                  <c:pt idx="3">
                    <c:v>0.3</c:v>
                  </c:pt>
                  <c:pt idx="4">
                    <c:v>0</c:v>
                  </c:pt>
                  <c:pt idx="5">
                    <c:v>1.1086778913041726</c:v>
                  </c:pt>
                  <c:pt idx="6">
                    <c:v>1.6</c:v>
                  </c:pt>
                  <c:pt idx="7">
                    <c:v>0</c:v>
                  </c:pt>
                </c:numCache>
              </c:numRef>
            </c:minus>
          </c:errBars>
          <c:val>
            <c:numRef>
              <c:f>AlSRK14!$N$17:$N$24</c:f>
              <c:numCache>
                <c:formatCode>General</c:formatCode>
                <c:ptCount val="8"/>
                <c:pt idx="0" formatCode="_(* #,##0.00_);_(* \(#,##0.00\);_(* &quot;-&quot;??_);_(@_)">
                  <c:v>0.7</c:v>
                </c:pt>
                <c:pt idx="1">
                  <c:v>0</c:v>
                </c:pt>
                <c:pt idx="2">
                  <c:v>2.7</c:v>
                </c:pt>
                <c:pt idx="3" formatCode="_(* #,##0.00_);_(* \(#,##0.00\);_(* &quot;-&quot;??_);_(@_)">
                  <c:v>0.7</c:v>
                </c:pt>
                <c:pt idx="4" formatCode="_-* #,##0\ _€_-;\-* #,##0\ _€_-;_-* &quot;-&quot;??\ _€_-;_-@_-">
                  <c:v>20</c:v>
                </c:pt>
                <c:pt idx="5" formatCode="0.00">
                  <c:v>3.25</c:v>
                </c:pt>
                <c:pt idx="6">
                  <c:v>4.3</c:v>
                </c:pt>
                <c:pt idx="7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1D50-254A-B775-74867D1158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0621568"/>
        <c:axId val="170627456"/>
      </c:barChart>
      <c:catAx>
        <c:axId val="170621568"/>
        <c:scaling>
          <c:orientation val="minMax"/>
        </c:scaling>
        <c:delete val="1"/>
        <c:axPos val="b"/>
        <c:majorTickMark val="out"/>
        <c:minorTickMark val="none"/>
        <c:tickLblPos val="nextTo"/>
        <c:crossAx val="170627456"/>
        <c:crosses val="autoZero"/>
        <c:auto val="1"/>
        <c:lblAlgn val="ctr"/>
        <c:lblOffset val="100"/>
        <c:noMultiLvlLbl val="0"/>
      </c:catAx>
      <c:valAx>
        <c:axId val="170627456"/>
        <c:scaling>
          <c:orientation val="minMax"/>
        </c:scaling>
        <c:delete val="1"/>
        <c:axPos val="l"/>
        <c:majorGridlines/>
        <c:numFmt formatCode="_(* #,##0.00_);_(* \(#,##0.00\);_(* &quot;-&quot;??_);_(@_)" sourceLinked="1"/>
        <c:majorTickMark val="out"/>
        <c:minorTickMark val="none"/>
        <c:tickLblPos val="nextTo"/>
        <c:crossAx val="17062156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Q-PCR raw data '!$M$3:$M$6</c:f>
                <c:numCache>
                  <c:formatCode>General</c:formatCode>
                  <c:ptCount val="4"/>
                  <c:pt idx="0">
                    <c:v>1.774522826785891</c:v>
                  </c:pt>
                  <c:pt idx="1">
                    <c:v>1.3877658767065546</c:v>
                  </c:pt>
                  <c:pt idx="2">
                    <c:v>2.8504008742307088</c:v>
                  </c:pt>
                  <c:pt idx="3">
                    <c:v>2.4323216466411833E-5</c:v>
                  </c:pt>
                </c:numCache>
              </c:numRef>
            </c:plus>
          </c:errBars>
          <c:val>
            <c:numRef>
              <c:f>'Q-PCR raw data '!$L$3:$L$6</c:f>
              <c:numCache>
                <c:formatCode>General</c:formatCode>
                <c:ptCount val="4"/>
                <c:pt idx="0">
                  <c:v>7.6234317995216117</c:v>
                </c:pt>
                <c:pt idx="1">
                  <c:v>8.2697819402252382</c:v>
                </c:pt>
                <c:pt idx="2">
                  <c:v>16.368674094986698</c:v>
                </c:pt>
                <c:pt idx="3">
                  <c:v>1.0109100992018597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FFE-AE4E-9582-DC955242BB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0754432"/>
        <c:axId val="170755968"/>
      </c:barChart>
      <c:catAx>
        <c:axId val="170754432"/>
        <c:scaling>
          <c:orientation val="minMax"/>
        </c:scaling>
        <c:delete val="1"/>
        <c:axPos val="b"/>
        <c:majorTickMark val="out"/>
        <c:minorTickMark val="none"/>
        <c:tickLblPos val="nextTo"/>
        <c:crossAx val="170755968"/>
        <c:crosses val="autoZero"/>
        <c:auto val="1"/>
        <c:lblAlgn val="ctr"/>
        <c:lblOffset val="100"/>
        <c:noMultiLvlLbl val="0"/>
      </c:catAx>
      <c:valAx>
        <c:axId val="170755968"/>
        <c:scaling>
          <c:orientation val="minMax"/>
          <c:max val="2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70754432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SCR pollination raw data'!$G$7,'SCR pollination raw data'!$G$10,'SCR pollination raw data'!$G$13,'SCR pollination raw data'!$G$16,'SCR pollination raw data'!$G$19)</c:f>
                <c:numCache>
                  <c:formatCode>General</c:formatCode>
                  <c:ptCount val="5"/>
                  <c:pt idx="0">
                    <c:v>0.39999999999999997</c:v>
                  </c:pt>
                  <c:pt idx="1">
                    <c:v>0</c:v>
                  </c:pt>
                  <c:pt idx="2">
                    <c:v>0.37416573867739417</c:v>
                  </c:pt>
                  <c:pt idx="3">
                    <c:v>1.2409673645990855</c:v>
                  </c:pt>
                  <c:pt idx="4">
                    <c:v>0.8539125638299665</c:v>
                  </c:pt>
                </c:numCache>
              </c:numRef>
            </c:plus>
            <c:minus>
              <c:numRef>
                <c:f>('SCR pollination raw data'!$G$7,'SCR pollination raw data'!$G$10,'SCR pollination raw data'!$G$13,'SCR pollination raw data'!$G$16,'SCR pollination raw data'!$G$19)</c:f>
                <c:numCache>
                  <c:formatCode>General</c:formatCode>
                  <c:ptCount val="5"/>
                  <c:pt idx="0">
                    <c:v>0.39999999999999997</c:v>
                  </c:pt>
                  <c:pt idx="1">
                    <c:v>0</c:v>
                  </c:pt>
                  <c:pt idx="2">
                    <c:v>0.37416573867739417</c:v>
                  </c:pt>
                  <c:pt idx="3">
                    <c:v>1.2409673645990855</c:v>
                  </c:pt>
                  <c:pt idx="4">
                    <c:v>0.8539125638299665</c:v>
                  </c:pt>
                </c:numCache>
              </c:numRef>
            </c:minus>
          </c:errBars>
          <c:val>
            <c:numRef>
              <c:f>('SCR pollination raw data'!$G$6,'SCR pollination raw data'!$G$9,'SCR pollination raw data'!$G$12,'SCR pollination raw data'!$G$15,'SCR pollination raw data'!$G$18)</c:f>
              <c:numCache>
                <c:formatCode>General</c:formatCode>
                <c:ptCount val="5"/>
                <c:pt idx="0">
                  <c:v>0.6</c:v>
                </c:pt>
                <c:pt idx="1">
                  <c:v>1</c:v>
                </c:pt>
                <c:pt idx="2">
                  <c:v>2.2000000000000002</c:v>
                </c:pt>
                <c:pt idx="3">
                  <c:v>4.2</c:v>
                </c:pt>
                <c:pt idx="4">
                  <c:v>1.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F30-F441-8ACD-1CE9E288FE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0773888"/>
        <c:axId val="170783872"/>
      </c:barChart>
      <c:catAx>
        <c:axId val="170773888"/>
        <c:scaling>
          <c:orientation val="minMax"/>
        </c:scaling>
        <c:delete val="1"/>
        <c:axPos val="b"/>
        <c:majorTickMark val="out"/>
        <c:minorTickMark val="none"/>
        <c:tickLblPos val="nextTo"/>
        <c:crossAx val="170783872"/>
        <c:crosses val="autoZero"/>
        <c:auto val="1"/>
        <c:lblAlgn val="ctr"/>
        <c:lblOffset val="100"/>
        <c:noMultiLvlLbl val="0"/>
      </c:catAx>
      <c:valAx>
        <c:axId val="170783872"/>
        <c:scaling>
          <c:orientation val="minMax"/>
          <c:max val="30"/>
        </c:scaling>
        <c:delete val="1"/>
        <c:axPos val="l"/>
        <c:majorGridlines/>
        <c:numFmt formatCode="General" sourceLinked="1"/>
        <c:majorTickMark val="out"/>
        <c:minorTickMark val="none"/>
        <c:tickLblPos val="nextTo"/>
        <c:crossAx val="17077388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46400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49688" y="2"/>
            <a:ext cx="2946400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r">
              <a:defRPr sz="1200"/>
            </a:lvl1pPr>
          </a:lstStyle>
          <a:p>
            <a:fld id="{32066541-3FA6-405F-B313-0A4D44B578E9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29751"/>
            <a:ext cx="2946400" cy="496888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49688" y="9429751"/>
            <a:ext cx="2946400" cy="496888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r">
              <a:defRPr sz="1200"/>
            </a:lvl1pPr>
          </a:lstStyle>
          <a:p>
            <a:fld id="{BD5A0937-3EEC-4ED6-9A41-C1ACE9C306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5184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50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177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400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375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209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04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516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357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811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646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823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98EDD-E4F4-43E6-9FEE-7032C34B478D}" type="datetimeFigureOut">
              <a:rPr lang="en-US" smtClean="0"/>
              <a:t>12/5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9D05B-6040-4670-9B3D-71A52F32B36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786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tiff"/><Relationship Id="rId18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8.wdp"/><Relationship Id="rId7" Type="http://schemas.microsoft.com/office/2007/relationships/hdphoto" Target="../media/hdphoto3.wdp"/><Relationship Id="rId12" Type="http://schemas.openxmlformats.org/officeDocument/2006/relationships/image" Target="../media/image9.tiff"/><Relationship Id="rId17" Type="http://schemas.microsoft.com/office/2007/relationships/hdphoto" Target="../media/hdphoto6.wdp"/><Relationship Id="rId2" Type="http://schemas.openxmlformats.org/officeDocument/2006/relationships/image" Target="../media/image3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8.tiff"/><Relationship Id="rId5" Type="http://schemas.microsoft.com/office/2007/relationships/hdphoto" Target="../media/hdphoto2.wdp"/><Relationship Id="rId15" Type="http://schemas.microsoft.com/office/2007/relationships/hdphoto" Target="../media/hdphoto5.wdp"/><Relationship Id="rId10" Type="http://schemas.openxmlformats.org/officeDocument/2006/relationships/image" Target="../media/image7.tiff"/><Relationship Id="rId19" Type="http://schemas.microsoft.com/office/2007/relationships/hdphoto" Target="../media/hdphoto7.wdp"/><Relationship Id="rId4" Type="http://schemas.openxmlformats.org/officeDocument/2006/relationships/image" Target="../media/image4.png"/><Relationship Id="rId9" Type="http://schemas.microsoft.com/office/2007/relationships/hdphoto" Target="../media/hdphoto4.wdp"/><Relationship Id="rId14" Type="http://schemas.openxmlformats.org/officeDocument/2006/relationships/image" Target="../media/image11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6.tif"/><Relationship Id="rId7" Type="http://schemas.openxmlformats.org/officeDocument/2006/relationships/image" Target="../media/image20.tif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5" Type="http://schemas.openxmlformats.org/officeDocument/2006/relationships/image" Target="../media/image18.tif"/><Relationship Id="rId4" Type="http://schemas.openxmlformats.org/officeDocument/2006/relationships/image" Target="../media/image17.tif"/><Relationship Id="rId9" Type="http://schemas.openxmlformats.org/officeDocument/2006/relationships/image" Target="../media/image22.tif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thermofisher.com/" TargetMode="Externa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7" Type="http://schemas.openxmlformats.org/officeDocument/2006/relationships/image" Target="../media/image32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tiff"/><Relationship Id="rId5" Type="http://schemas.openxmlformats.org/officeDocument/2006/relationships/image" Target="../media/image30.tiff"/><Relationship Id="rId4" Type="http://schemas.openxmlformats.org/officeDocument/2006/relationships/image" Target="../media/image29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image" Target="../media/image2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3564" y="611560"/>
            <a:ext cx="626469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itle: Live-cell imaging of early events following pollen perception in self-incompatible </a:t>
            </a:r>
            <a:r>
              <a:rPr lang="en-US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rabidopsis</a:t>
            </a:r>
          </a:p>
          <a:p>
            <a:r>
              <a:rPr lang="en-US" sz="10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thaliana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213361" y="282878"/>
            <a:ext cx="2268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Data</a:t>
            </a:r>
          </a:p>
        </p:txBody>
      </p:sp>
      <p:sp>
        <p:nvSpPr>
          <p:cNvPr id="5" name="Rectangle 4"/>
          <p:cNvSpPr/>
          <p:nvPr/>
        </p:nvSpPr>
        <p:spPr>
          <a:xfrm>
            <a:off x="213361" y="1219562"/>
            <a:ext cx="612068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Author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: Frédérique Rozier, Lucie Riglet, Chie Kodera, Vincent Bayle, Eléonore Durand,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Jonathan Schnabel, Thierry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Gaude and Isabelle Fobis-Loisy</a:t>
            </a:r>
          </a:p>
        </p:txBody>
      </p:sp>
      <p:sp>
        <p:nvSpPr>
          <p:cNvPr id="9" name="Rectangle 8"/>
          <p:cNvSpPr/>
          <p:nvPr/>
        </p:nvSpPr>
        <p:spPr>
          <a:xfrm>
            <a:off x="213361" y="1691680"/>
            <a:ext cx="6145401" cy="40164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Protocol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1-S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: supporting material</a:t>
            </a:r>
          </a:p>
          <a:p>
            <a:pPr>
              <a:lnSpc>
                <a:spcPct val="150000"/>
              </a:lnSpc>
            </a:pPr>
            <a:r>
              <a:rPr lang="en-US" sz="1000" b="1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</a:t>
            </a:r>
            <a:r>
              <a:rPr lang="en-US" sz="1000" i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i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Transgenic plant selection</a:t>
            </a:r>
          </a:p>
          <a:p>
            <a:pPr lvl="0">
              <a:lnSpc>
                <a:spcPct val="150000"/>
              </a:lnSpc>
            </a:pPr>
            <a:r>
              <a:rPr lang="en-US" sz="1000" b="1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Dual pollination with compatible and incompatible pollen deposited on the same stigma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</a:t>
            </a: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ctin rearrangement at the pollen contact site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Actin rearrangement along the pollen tube path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Actin behavior in stigmatic cells in contact with incompatible pollen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Tabl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L/W ratio of pollen grains coming out of mature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nthers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: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Dynamics of actin focalization following compatible pollination</a:t>
            </a:r>
            <a:endParaRPr 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Hydration kinetics of compatible and incompatible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ollens 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in the semi </a:t>
            </a:r>
            <a:r>
              <a:rPr lang="en-US" sz="1000" i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in vivo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system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Tabl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</a:t>
            </a: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Germination of compatible pollen tracked during experiments described in figure 5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Standard and high humidity assays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5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Behavior of compatible pollen in high humidity conditions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5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Compatible pollen germination and pollen tube growth in high humidity conditions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6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Behavior of incompatible pollen in high humidity conditions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Tabl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L/W ratio of incompatible pollen in high humidity conditions 10 minutes after pollen deposition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6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Incompatible pollen germination and pollen tube growth in high humidity conditions</a:t>
            </a:r>
          </a:p>
          <a:p>
            <a:pPr lvl="0">
              <a:lnSpc>
                <a:spcPct val="150000"/>
              </a:lnSpc>
            </a:pPr>
            <a:r>
              <a:rPr lang="en-US" sz="1000" b="1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sz="1000" b="1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7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: </a:t>
            </a:r>
            <a:r>
              <a:rPr lang="en-US" sz="1000" dirty="0" err="1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M4</a:t>
            </a:r>
            <a:r>
              <a:rPr lang="en-US" sz="1000" dirty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64 labelling of stigmatic </a:t>
            </a:r>
            <a:r>
              <a:rPr lang="en-US" sz="1000" dirty="0" smtClean="0">
                <a:solidFill>
                  <a:prstClr val="black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ells</a:t>
            </a:r>
            <a:endParaRPr lang="en-US" sz="1000" dirty="0">
              <a:solidFill>
                <a:prstClr val="black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99209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6" name="Rectangle 5"/>
          <p:cNvSpPr/>
          <p:nvPr/>
        </p:nvSpPr>
        <p:spPr>
          <a:xfrm>
            <a:off x="386886" y="755576"/>
            <a:ext cx="5994442" cy="12176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ctin rearrangement along the pollen tube path. 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tigma (green fluorescence) was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ual-pollinated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nd we focused on one stigmatic cell in contact with a compatible pollen (blue fluorescence). A Z-stack was taken every minute after pollen deposition. Images were processed with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image J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o generate a Z-projection at each time poi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struct the video. Indicated time corresponds to time after pollen deposition. Bar 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24928095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3" name="Rectangle 2"/>
          <p:cNvSpPr/>
          <p:nvPr/>
        </p:nvSpPr>
        <p:spPr>
          <a:xfrm>
            <a:off x="386886" y="755576"/>
            <a:ext cx="5994442" cy="12176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ctin behavior in stigmatic cells in contact with incompatible pollen. 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tigma (green fluorescence) was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ual-pollinated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 Z-stack was taken every minute after pollen deposition. Images were processed with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image J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o generate a Z-projection at each time poi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struct the video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dicated time corresponds to time after pollen deposition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The selected stigma is representative of the seven tracked stigmas. Ba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363266815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2665043"/>
              </p:ext>
            </p:extLst>
          </p:nvPr>
        </p:nvGraphicFramePr>
        <p:xfrm>
          <a:off x="980728" y="1187624"/>
          <a:ext cx="3672408" cy="14833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4508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5916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0243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       pollen from anth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7363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24</a:t>
                      </a:r>
                      <a:r>
                        <a:rPr lang="en-US" sz="1000" i="1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URQ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24</a:t>
                      </a:r>
                      <a:r>
                        <a:rPr lang="en-US" sz="1000" i="1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CR14+RFP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024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</a:t>
                      </a:r>
                      <a:r>
                        <a:rPr lang="en-US" sz="1000" u="none" strike="noStrike" dirty="0" smtClean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an </a:t>
                      </a:r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/W ratio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9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024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0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0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024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224374" y="282878"/>
            <a:ext cx="2268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endParaRPr 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97071" y="688724"/>
            <a:ext cx="554461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L/W ratio of pollen grains at anthesis</a:t>
            </a:r>
          </a:p>
        </p:txBody>
      </p:sp>
    </p:spTree>
    <p:extLst>
      <p:ext uri="{BB962C8B-B14F-4D97-AF65-F5344CB8AC3E}">
        <p14:creationId xmlns:p14="http://schemas.microsoft.com/office/powerpoint/2010/main" val="23345654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6" name="Picture 42" descr="Z:\pollination Group\frédérique\Article\raw data for publication\images\supdata\supfigure3\rank 112-27min.tif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0359" y="5717417"/>
            <a:ext cx="1319130" cy="15784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7" name="Picture 43" descr="Z:\pollination Group\frédérique\Article\raw data for publication\images\supdata\supfigure3\rank 112-28min.tif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2083" y="5717417"/>
            <a:ext cx="1319130" cy="15784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8" name="Picture 44" descr="Z:\pollination Group\frédérique\Article\raw data for publication\images\supdata\supfigure3\rank 112-30min.tif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9398" y="5717417"/>
            <a:ext cx="1319130" cy="15784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9" name="Picture 45" descr="Z:\pollination Group\frédérique\Article\raw data for publication\images\supdata\supfigure3\rank 112-26min.tif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812" y="5717417"/>
            <a:ext cx="1319130" cy="15784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2" name="Picture 38" descr="Z:\pollination Group\frédérique\Article\raw data for publication\images\supdata\supfigure3\rank 121-15min.tif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495" y="3623845"/>
            <a:ext cx="1097010" cy="2032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3" name="Picture 39" descr="Z:\pollination Group\frédérique\Article\raw data for publication\images\supdata\supfigure3\rank 121-16min.tif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0914" y="3623845"/>
            <a:ext cx="1097010" cy="2032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4" name="Picture 40" descr="Z:\pollination Group\frédérique\Article\raw data for publication\images\supdata\supfigure3\rank 121-17min.tif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9538" y="3623845"/>
            <a:ext cx="1097010" cy="2032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5" name="Picture 41" descr="Z:\pollination Group\frédérique\Article\raw data for publication\images\supdata\supfigure3\rank 121-18min.tif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6101" y="3623845"/>
            <a:ext cx="1097010" cy="2032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ZoneTexte 4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31" name="Rectangle 30"/>
          <p:cNvSpPr/>
          <p:nvPr/>
        </p:nvSpPr>
        <p:spPr>
          <a:xfrm>
            <a:off x="231100" y="617702"/>
            <a:ext cx="604867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/>
              <a:t>Dynamics of actin focalization following compatible pollination</a:t>
            </a:r>
            <a:r>
              <a:rPr lang="en-US" sz="1000" dirty="0" smtClean="0"/>
              <a:t>. Examples of the three categories defined in Figure </a:t>
            </a:r>
            <a:r>
              <a:rPr lang="en-US" sz="1000" dirty="0" err="1" smtClean="0"/>
              <a:t>4B</a:t>
            </a:r>
            <a:r>
              <a:rPr lang="en-US" sz="1000" dirty="0" smtClean="0"/>
              <a:t>. (A) Actin </a:t>
            </a:r>
            <a:r>
              <a:rPr lang="en-US" sz="1000" dirty="0"/>
              <a:t>reorganization in </a:t>
            </a:r>
            <a:r>
              <a:rPr lang="en-US" sz="1000" dirty="0" smtClean="0"/>
              <a:t>papillae before pollen germination (42 %), (B) during germination (8 %) and (C) after germination (42%). </a:t>
            </a:r>
            <a:r>
              <a:rPr lang="en-US" sz="1000" dirty="0"/>
              <a:t>Indicated time corresponds to time after pollen deposition. Images are </a:t>
            </a:r>
            <a:r>
              <a:rPr lang="en-US" sz="1000" dirty="0" smtClean="0"/>
              <a:t>Z-projections. White Arrow shows the earliest focalization </a:t>
            </a:r>
            <a:r>
              <a:rPr lang="en-US" sz="1000" dirty="0"/>
              <a:t>of actin </a:t>
            </a:r>
            <a:r>
              <a:rPr lang="en-US" sz="1000" dirty="0" smtClean="0"/>
              <a:t>fluorescence. </a:t>
            </a:r>
            <a:r>
              <a:rPr lang="en-US" sz="1000" dirty="0" smtClean="0">
                <a:cs typeface="Helvetica" panose="020B0604020202020204" pitchFamily="34" charset="0"/>
              </a:rPr>
              <a:t>Bar </a:t>
            </a:r>
            <a:r>
              <a:rPr lang="en-US" sz="1000" dirty="0">
                <a:cs typeface="Helvetica" panose="020B0604020202020204" pitchFamily="34" charset="0"/>
              </a:rPr>
              <a:t>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cs typeface="Helvetica" panose="020B0604020202020204" pitchFamily="34" charset="0"/>
              </a:rPr>
              <a:t>m.</a:t>
            </a:r>
          </a:p>
        </p:txBody>
      </p:sp>
      <p:sp>
        <p:nvSpPr>
          <p:cNvPr id="56" name="ZoneTexte 55"/>
          <p:cNvSpPr txBox="1"/>
          <p:nvPr/>
        </p:nvSpPr>
        <p:spPr>
          <a:xfrm>
            <a:off x="3636925" y="1949516"/>
            <a:ext cx="9422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G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rmination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7" name="ZoneTexte 96"/>
          <p:cNvSpPr txBox="1"/>
          <p:nvPr/>
        </p:nvSpPr>
        <p:spPr>
          <a:xfrm>
            <a:off x="1088135" y="3623846"/>
            <a:ext cx="689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5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8" name="ZoneTexte 97"/>
          <p:cNvSpPr txBox="1"/>
          <p:nvPr/>
        </p:nvSpPr>
        <p:spPr>
          <a:xfrm>
            <a:off x="1190786" y="5708382"/>
            <a:ext cx="692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6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11" name="Connecteur droit 110"/>
          <p:cNvCxnSpPr/>
          <p:nvPr/>
        </p:nvCxnSpPr>
        <p:spPr>
          <a:xfrm>
            <a:off x="4899753" y="1929280"/>
            <a:ext cx="0" cy="55091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ZoneTexte 121"/>
          <p:cNvSpPr txBox="1"/>
          <p:nvPr/>
        </p:nvSpPr>
        <p:spPr>
          <a:xfrm>
            <a:off x="2730295" y="5719608"/>
            <a:ext cx="692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7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3" name="ZoneTexte 122"/>
          <p:cNvSpPr txBox="1"/>
          <p:nvPr/>
        </p:nvSpPr>
        <p:spPr>
          <a:xfrm>
            <a:off x="4242431" y="5717417"/>
            <a:ext cx="692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8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4" name="ZoneTexte 123"/>
          <p:cNvSpPr txBox="1"/>
          <p:nvPr/>
        </p:nvSpPr>
        <p:spPr>
          <a:xfrm>
            <a:off x="5825372" y="5717417"/>
            <a:ext cx="692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0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7" name="ZoneTexte 126"/>
          <p:cNvSpPr txBox="1"/>
          <p:nvPr/>
        </p:nvSpPr>
        <p:spPr>
          <a:xfrm>
            <a:off x="2696554" y="3623846"/>
            <a:ext cx="689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6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4143512" y="3623846"/>
            <a:ext cx="689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7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5721741" y="3621276"/>
            <a:ext cx="689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8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45" name="Connecteur droit avec flèche 144"/>
          <p:cNvCxnSpPr/>
          <p:nvPr/>
        </p:nvCxnSpPr>
        <p:spPr>
          <a:xfrm flipV="1">
            <a:off x="3963218" y="4556254"/>
            <a:ext cx="97773" cy="221694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Connecteur droit avec flèche 146"/>
          <p:cNvCxnSpPr/>
          <p:nvPr/>
        </p:nvCxnSpPr>
        <p:spPr>
          <a:xfrm flipH="1" flipV="1">
            <a:off x="5810879" y="6572478"/>
            <a:ext cx="199834" cy="7200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ZoneTexte 151"/>
          <p:cNvSpPr txBox="1"/>
          <p:nvPr/>
        </p:nvSpPr>
        <p:spPr>
          <a:xfrm>
            <a:off x="463427" y="361151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3" name="ZoneTexte 152"/>
          <p:cNvSpPr txBox="1"/>
          <p:nvPr/>
        </p:nvSpPr>
        <p:spPr>
          <a:xfrm>
            <a:off x="392827" y="570838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58" name="Connecteur droit 157"/>
          <p:cNvCxnSpPr/>
          <p:nvPr/>
        </p:nvCxnSpPr>
        <p:spPr>
          <a:xfrm>
            <a:off x="3345186" y="1907704"/>
            <a:ext cx="0" cy="55091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74" name="Picture 50" descr="Z:\pollination Group\frédérique\Article\raw data for publication\images\supdata\supfigure3\rank 100-10min.tif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719"/>
          <a:stretch/>
        </p:blipFill>
        <p:spPr bwMode="auto">
          <a:xfrm>
            <a:off x="338139" y="2202610"/>
            <a:ext cx="1443602" cy="1368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5" name="Picture 51" descr="Z:\pollination Group\frédérique\Article\raw data for publication\images\supdata\supfigure3\rank 100-11min.tif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719"/>
          <a:stretch/>
        </p:blipFill>
        <p:spPr bwMode="auto">
          <a:xfrm>
            <a:off x="1843487" y="2202610"/>
            <a:ext cx="1443602" cy="1368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6" name="Picture 52" descr="Z:\pollination Group\frédérique\Article\raw data for publication\images\supdata\supfigure3\rank 100-12min.tif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719"/>
          <a:stretch/>
        </p:blipFill>
        <p:spPr bwMode="auto">
          <a:xfrm>
            <a:off x="3406287" y="2202610"/>
            <a:ext cx="1443602" cy="1368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7" name="Picture 53" descr="Z:\pollination Group\frédérique\Article\raw data for publication\images\supdata\supfigure3\rank 100-13min.tif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719"/>
          <a:stretch/>
        </p:blipFill>
        <p:spPr bwMode="auto">
          <a:xfrm>
            <a:off x="4970209" y="2202610"/>
            <a:ext cx="1443602" cy="1368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7" name="ZoneTexte 166"/>
          <p:cNvSpPr txBox="1"/>
          <p:nvPr/>
        </p:nvSpPr>
        <p:spPr>
          <a:xfrm>
            <a:off x="1251362" y="2202610"/>
            <a:ext cx="728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0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8" name="ZoneTexte 167"/>
          <p:cNvSpPr txBox="1"/>
          <p:nvPr/>
        </p:nvSpPr>
        <p:spPr>
          <a:xfrm>
            <a:off x="2740288" y="2202610"/>
            <a:ext cx="728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1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9" name="ZoneTexte 168"/>
          <p:cNvSpPr txBox="1"/>
          <p:nvPr/>
        </p:nvSpPr>
        <p:spPr>
          <a:xfrm>
            <a:off x="4320916" y="2195736"/>
            <a:ext cx="728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2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0" name="ZoneTexte 169"/>
          <p:cNvSpPr txBox="1"/>
          <p:nvPr/>
        </p:nvSpPr>
        <p:spPr>
          <a:xfrm>
            <a:off x="5868870" y="2202610"/>
            <a:ext cx="728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3 min</a:t>
            </a:r>
            <a:endParaRPr lang="en-US" sz="1000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71" name="Connecteur droit avec flèche 170"/>
          <p:cNvCxnSpPr/>
          <p:nvPr/>
        </p:nvCxnSpPr>
        <p:spPr>
          <a:xfrm flipH="1">
            <a:off x="1224491" y="2690081"/>
            <a:ext cx="208519" cy="1524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ZoneTexte 172"/>
          <p:cNvSpPr txBox="1"/>
          <p:nvPr/>
        </p:nvSpPr>
        <p:spPr>
          <a:xfrm>
            <a:off x="314990" y="220141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49369152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172308" y="2582330"/>
            <a:ext cx="3821743" cy="2277702"/>
            <a:chOff x="1280136" y="1396975"/>
            <a:chExt cx="3821743" cy="2277702"/>
          </a:xfrm>
        </p:grpSpPr>
        <p:sp>
          <p:nvSpPr>
            <p:cNvPr id="3" name="ZoneTexte 2"/>
            <p:cNvSpPr txBox="1"/>
            <p:nvPr/>
          </p:nvSpPr>
          <p:spPr>
            <a:xfrm>
              <a:off x="1280136" y="1396975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</a:p>
          </p:txBody>
        </p:sp>
        <p:sp>
          <p:nvSpPr>
            <p:cNvPr id="4" name="ZoneTexte 3"/>
            <p:cNvSpPr txBox="1"/>
            <p:nvPr/>
          </p:nvSpPr>
          <p:spPr>
            <a:xfrm flipH="1">
              <a:off x="1280136" y="2523711"/>
              <a:ext cx="2288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64" t="1" b="18161"/>
            <a:stretch/>
          </p:blipFill>
          <p:spPr>
            <a:xfrm>
              <a:off x="1484784" y="1455595"/>
              <a:ext cx="879005" cy="1068116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24" t="3911" r="4718" b="14252"/>
            <a:stretch/>
          </p:blipFill>
          <p:spPr>
            <a:xfrm>
              <a:off x="2386573" y="1455595"/>
              <a:ext cx="875835" cy="1068116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4" t="7214" r="16917" b="10949"/>
            <a:stretch/>
          </p:blipFill>
          <p:spPr>
            <a:xfrm>
              <a:off x="3286213" y="1455595"/>
              <a:ext cx="875835" cy="1068116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6" t="8730" r="21866" b="9432"/>
            <a:stretch/>
          </p:blipFill>
          <p:spPr>
            <a:xfrm>
              <a:off x="4178914" y="1455595"/>
              <a:ext cx="875835" cy="1068116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02" r="23468"/>
            <a:stretch/>
          </p:blipFill>
          <p:spPr>
            <a:xfrm>
              <a:off x="1484784" y="2606560"/>
              <a:ext cx="874401" cy="1068117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467" b="4502"/>
            <a:stretch/>
          </p:blipFill>
          <p:spPr>
            <a:xfrm>
              <a:off x="2386573" y="2606560"/>
              <a:ext cx="874408" cy="1068117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41" r="13301" b="4502"/>
            <a:stretch/>
          </p:blipFill>
          <p:spPr>
            <a:xfrm>
              <a:off x="3286213" y="2606560"/>
              <a:ext cx="875835" cy="1068117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71" t="-156" r="11671" b="4657"/>
            <a:stretch/>
          </p:blipFill>
          <p:spPr>
            <a:xfrm>
              <a:off x="4178914" y="2606560"/>
              <a:ext cx="875835" cy="1068117"/>
            </a:xfrm>
            <a:prstGeom prst="rect">
              <a:avLst/>
            </a:prstGeom>
          </p:spPr>
        </p:pic>
        <p:cxnSp>
          <p:nvCxnSpPr>
            <p:cNvPr id="13" name="Connecteur droit 12"/>
            <p:cNvCxnSpPr/>
            <p:nvPr/>
          </p:nvCxnSpPr>
          <p:spPr>
            <a:xfrm>
              <a:off x="4917457" y="2447526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3981353" y="2447526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14"/>
            <p:cNvCxnSpPr/>
            <p:nvPr/>
          </p:nvCxnSpPr>
          <p:spPr>
            <a:xfrm>
              <a:off x="3107548" y="2447526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>
              <a:off x="4896718" y="3584160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16"/>
            <p:cNvCxnSpPr/>
            <p:nvPr/>
          </p:nvCxnSpPr>
          <p:spPr>
            <a:xfrm>
              <a:off x="3991468" y="3584160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/>
            <p:cNvCxnSpPr/>
            <p:nvPr/>
          </p:nvCxnSpPr>
          <p:spPr>
            <a:xfrm>
              <a:off x="3107047" y="3584160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18"/>
            <p:cNvCxnSpPr/>
            <p:nvPr/>
          </p:nvCxnSpPr>
          <p:spPr>
            <a:xfrm>
              <a:off x="2189035" y="3584160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ZoneTexte 19"/>
            <p:cNvSpPr txBox="1"/>
            <p:nvPr/>
          </p:nvSpPr>
          <p:spPr>
            <a:xfrm>
              <a:off x="1947237" y="1425762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2 min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947237" y="2575564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2 min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2774084" y="1420596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2 min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2774084" y="2570398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2 min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3671123" y="1425762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8 min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3678263" y="2575564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8 min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4570964" y="1420596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24 min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4570964" y="2570398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24 min</a:t>
              </a:r>
            </a:p>
          </p:txBody>
        </p:sp>
        <p:cxnSp>
          <p:nvCxnSpPr>
            <p:cNvPr id="28" name="Connecteur droit 27"/>
            <p:cNvCxnSpPr/>
            <p:nvPr/>
          </p:nvCxnSpPr>
          <p:spPr>
            <a:xfrm>
              <a:off x="2193460" y="2447526"/>
              <a:ext cx="1044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29"/>
            <p:cNvCxnSpPr/>
            <p:nvPr/>
          </p:nvCxnSpPr>
          <p:spPr>
            <a:xfrm>
              <a:off x="1831555" y="1864605"/>
              <a:ext cx="170761" cy="8262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35"/>
            <p:cNvCxnSpPr/>
            <p:nvPr/>
          </p:nvCxnSpPr>
          <p:spPr>
            <a:xfrm flipH="1">
              <a:off x="1908672" y="1699942"/>
              <a:ext cx="18368" cy="34644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37"/>
            <p:cNvCxnSpPr/>
            <p:nvPr/>
          </p:nvCxnSpPr>
          <p:spPr>
            <a:xfrm flipH="1">
              <a:off x="2743200" y="1692507"/>
              <a:ext cx="38767" cy="322147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>
              <a:off x="1973017" y="3056183"/>
              <a:ext cx="156492" cy="42958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>
              <a:off x="2649311" y="1834868"/>
              <a:ext cx="220269" cy="3482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cteur droit avec flèche 46"/>
            <p:cNvCxnSpPr/>
            <p:nvPr/>
          </p:nvCxnSpPr>
          <p:spPr>
            <a:xfrm flipH="1" flipV="1">
              <a:off x="3608722" y="1980449"/>
              <a:ext cx="89888" cy="100371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cteur droit 51"/>
            <p:cNvCxnSpPr/>
            <p:nvPr/>
          </p:nvCxnSpPr>
          <p:spPr>
            <a:xfrm flipH="1">
              <a:off x="2015976" y="2916716"/>
              <a:ext cx="81832" cy="299026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55"/>
            <p:cNvCxnSpPr/>
            <p:nvPr/>
          </p:nvCxnSpPr>
          <p:spPr>
            <a:xfrm>
              <a:off x="2906249" y="3002998"/>
              <a:ext cx="156492" cy="42958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>
              <a:off x="3755031" y="2902215"/>
              <a:ext cx="156492" cy="42958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57"/>
            <p:cNvCxnSpPr/>
            <p:nvPr/>
          </p:nvCxnSpPr>
          <p:spPr>
            <a:xfrm>
              <a:off x="4636502" y="2843808"/>
              <a:ext cx="156492" cy="42958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58"/>
            <p:cNvCxnSpPr/>
            <p:nvPr/>
          </p:nvCxnSpPr>
          <p:spPr>
            <a:xfrm flipH="1">
              <a:off x="2947759" y="2860002"/>
              <a:ext cx="81832" cy="299026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cteur droit 59"/>
            <p:cNvCxnSpPr/>
            <p:nvPr/>
          </p:nvCxnSpPr>
          <p:spPr>
            <a:xfrm flipH="1">
              <a:off x="3814091" y="2757157"/>
              <a:ext cx="56781" cy="305162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/>
            <p:cNvCxnSpPr/>
            <p:nvPr/>
          </p:nvCxnSpPr>
          <p:spPr>
            <a:xfrm flipH="1">
              <a:off x="4698890" y="2706379"/>
              <a:ext cx="57217" cy="30871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ZoneTexte 4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31" name="Rectangle 30"/>
          <p:cNvSpPr/>
          <p:nvPr/>
        </p:nvSpPr>
        <p:spPr>
          <a:xfrm>
            <a:off x="301102" y="827584"/>
            <a:ext cx="6048672" cy="12464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Hydration kinetics of compatible and </a:t>
            </a:r>
            <a:r>
              <a:rPr lang="en-US" sz="1000">
                <a:latin typeface="Helvetica" panose="020B0604020202020204" pitchFamily="34" charset="0"/>
                <a:cs typeface="Helvetica" panose="020B0604020202020204" pitchFamily="34" charset="0"/>
              </a:rPr>
              <a:t>incompatible </a:t>
            </a:r>
            <a:r>
              <a:rPr lang="en-US" sz="1000" smtClean="0">
                <a:latin typeface="Helvetica" panose="020B0604020202020204" pitchFamily="34" charset="0"/>
                <a:cs typeface="Helvetica" panose="020B0604020202020204" pitchFamily="34" charset="0"/>
              </a:rPr>
              <a:t>pollens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 the semi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in vivo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ystem. Images are Z-projections and correspond to enlargement of the pollinated stigma shown in supplementary video S1. Indicated time corresponds to the time after pollen deposition. (A)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Length and width (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white lines) of one compatible pollen grain. Emergence of a pollen tube (arrow) occurs after 18 minutes. (B) Length and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idth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of one incompatible pollen grain. Bar 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353890281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24374" y="282878"/>
            <a:ext cx="1692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endParaRPr 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8546364"/>
              </p:ext>
            </p:extLst>
          </p:nvPr>
        </p:nvGraphicFramePr>
        <p:xfrm>
          <a:off x="1095383" y="1547664"/>
          <a:ext cx="4493857" cy="47377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4999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70370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40160"/>
              </a:tblGrid>
              <a:tr h="360040">
                <a:tc>
                  <a:txBody>
                    <a:bodyPr/>
                    <a:lstStyle/>
                    <a:p>
                      <a:pPr algn="ctr"/>
                      <a:r>
                        <a:rPr lang="en-US" sz="1100" b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ime after pollen deposition 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u="none" strike="noStrike" dirty="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% of grains having germinate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ean L/W ratio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%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6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%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76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6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%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8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%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5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%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9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57141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2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% (3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 smtClean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1</a:t>
                      </a:r>
                      <a:endParaRPr lang="en-US" sz="1100" u="none" strike="noStrike" dirty="0"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4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5.5% (9/58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6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% (14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8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3% (19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0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3% (25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2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60% (35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1% (41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6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4% (49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8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1% (53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0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6.5% (56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701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2 mi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0% (58/58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494539" y="683568"/>
            <a:ext cx="59766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Germination of compatible pollen tracked during experiments described in figure 5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When a pollen grain germinated, it is not anymore included in the L/W ratio calculation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80694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1101481" y="1958569"/>
            <a:ext cx="4083340" cy="2037367"/>
            <a:chOff x="1101481" y="1543220"/>
            <a:chExt cx="4083340" cy="2037367"/>
          </a:xfrm>
        </p:grpSpPr>
        <p:pic>
          <p:nvPicPr>
            <p:cNvPr id="1031" name="Picture 7" descr="Z:\pollination Group\frédérique\Article\suivi croissance tube\images\montage hydraté X5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84622" y="1763688"/>
              <a:ext cx="1800199" cy="18168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 descr="Z:\pollination Group\frédérique\Article\suivi croissance tube\images\montage normal X5scale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391" y="1763688"/>
              <a:ext cx="1800200" cy="18168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" name="Connecteur droit 3"/>
            <p:cNvCxnSpPr/>
            <p:nvPr/>
          </p:nvCxnSpPr>
          <p:spPr>
            <a:xfrm>
              <a:off x="4968799" y="3510928"/>
              <a:ext cx="12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2880567" y="3515018"/>
              <a:ext cx="12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/>
            <p:cNvSpPr txBox="1"/>
            <p:nvPr/>
          </p:nvSpPr>
          <p:spPr>
            <a:xfrm>
              <a:off x="1101481" y="1640577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3194736" y="1640576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452471" y="1550445"/>
              <a:ext cx="13099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Standard conditions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473973" y="1543220"/>
              <a:ext cx="15680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High humidity conditions</a:t>
              </a:r>
            </a:p>
          </p:txBody>
        </p:sp>
        <p:cxnSp>
          <p:nvCxnSpPr>
            <p:cNvPr id="5" name="Connecteur droit avec flèche 4"/>
            <p:cNvCxnSpPr/>
            <p:nvPr/>
          </p:nvCxnSpPr>
          <p:spPr>
            <a:xfrm flipV="1">
              <a:off x="1772816" y="2843808"/>
              <a:ext cx="144016" cy="18002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ZoneTexte 7"/>
            <p:cNvSpPr txBox="1"/>
            <p:nvPr/>
          </p:nvSpPr>
          <p:spPr>
            <a:xfrm>
              <a:off x="1418137" y="2982884"/>
              <a:ext cx="10631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Pollinated stigma</a:t>
              </a:r>
            </a:p>
          </p:txBody>
        </p:sp>
        <p:cxnSp>
          <p:nvCxnSpPr>
            <p:cNvPr id="15" name="Connecteur droit avec flèche 14"/>
            <p:cNvCxnSpPr/>
            <p:nvPr/>
          </p:nvCxnSpPr>
          <p:spPr>
            <a:xfrm flipV="1">
              <a:off x="4004981" y="2857132"/>
              <a:ext cx="144016" cy="18002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/>
            <p:cNvSpPr txBox="1"/>
            <p:nvPr/>
          </p:nvSpPr>
          <p:spPr>
            <a:xfrm>
              <a:off x="3650302" y="2996208"/>
              <a:ext cx="10631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Pollinated stigma</a:t>
              </a:r>
            </a:p>
          </p:txBody>
        </p:sp>
      </p:grpSp>
      <p:sp>
        <p:nvSpPr>
          <p:cNvPr id="20" name="ZoneTexte 19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2" name="Rectangle 1"/>
          <p:cNvSpPr/>
          <p:nvPr/>
        </p:nvSpPr>
        <p:spPr>
          <a:xfrm>
            <a:off x="386424" y="803484"/>
            <a:ext cx="5616624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tandard and high humidity assays.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(A) Stigma in contact with the coverslip 30 minutes after pollination in standard conditions. (B) Stigma in contact with the coverslip 30 minutes after pollination in high humidity conditions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a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= 10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378361873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5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19" name="Rectangle 18"/>
          <p:cNvSpPr/>
          <p:nvPr/>
        </p:nvSpPr>
        <p:spPr>
          <a:xfrm>
            <a:off x="266158" y="755576"/>
            <a:ext cx="608004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5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Behavior of compatible pollen in high humidity conditions . (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)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Features of compatible pollination in high humidity conditions. 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marker stigma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as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inated with compatible polle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nd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cubated in high humidity conditions for 40 minutes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ou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depende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xperiments. (B) Actin (green fluorescence)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focalization (white asterisks) in stigmatic cells in contact with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lue-fluorescent germinated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e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ains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mage is a single confocal section, 40 minutes after polle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eposition. Ba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= 5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  <p:sp>
        <p:nvSpPr>
          <p:cNvPr id="56" name="ZoneTexte 55"/>
          <p:cNvSpPr txBox="1"/>
          <p:nvPr/>
        </p:nvSpPr>
        <p:spPr>
          <a:xfrm>
            <a:off x="854013" y="2483768"/>
            <a:ext cx="253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grpSp>
        <p:nvGrpSpPr>
          <p:cNvPr id="57" name="Groupe 56"/>
          <p:cNvGrpSpPr/>
          <p:nvPr/>
        </p:nvGrpSpPr>
        <p:grpSpPr>
          <a:xfrm>
            <a:off x="1359174" y="4147637"/>
            <a:ext cx="3529492" cy="3748811"/>
            <a:chOff x="1127551" y="2639659"/>
            <a:chExt cx="3529492" cy="3748811"/>
          </a:xfrm>
        </p:grpSpPr>
        <p:pic>
          <p:nvPicPr>
            <p:cNvPr id="58" name="Picture 2" descr="Z:\pollination Group\frédérique\Article\compatible_high humidity\29052019 stigma 2\vue d'ensemble-Zproject5slides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37203" y="2698073"/>
              <a:ext cx="3076405" cy="36506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9" name="ZoneTexte 58"/>
            <p:cNvSpPr txBox="1"/>
            <p:nvPr/>
          </p:nvSpPr>
          <p:spPr>
            <a:xfrm>
              <a:off x="1127551" y="2639659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2716001" y="3937571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4141655" y="352915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4513027" y="3258165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2720303" y="401916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2188771" y="4364001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2051932" y="4426860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2397117" y="4739428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2571211" y="4628523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2759382" y="4847150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1914448" y="5574897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1477359" y="5479193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3863421" y="47362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3125375" y="5064606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3089293" y="5587568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3050101" y="504314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3589587" y="4210691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1789486" y="5137657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2643219" y="3728268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2757091" y="2784690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3405888" y="563741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2648295" y="5980176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2355643" y="5954049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2680680" y="6173026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1835746" y="5848852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1557751" y="552643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*</a:t>
              </a:r>
            </a:p>
          </p:txBody>
        </p:sp>
      </p:grp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0758116"/>
              </p:ext>
            </p:extLst>
          </p:nvPr>
        </p:nvGraphicFramePr>
        <p:xfrm>
          <a:off x="2780928" y="2606878"/>
          <a:ext cx="3233883" cy="10256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4708"/>
                <a:gridCol w="504056"/>
                <a:gridCol w="1107047"/>
                <a:gridCol w="648072"/>
              </a:tblGrid>
              <a:tr h="654854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rmination time (min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M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% of papilla exhibiting actin focaliz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llen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umber</a:t>
                      </a:r>
                    </a:p>
                    <a:p>
                      <a:pPr algn="ctr"/>
                      <a:endParaRPr lang="en-US" sz="1000" b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8.55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2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4</a:t>
                      </a:r>
                      <a:endParaRPr lang="en-US" sz="10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37" name="Tableau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521659"/>
              </p:ext>
            </p:extLst>
          </p:nvPr>
        </p:nvGraphicFramePr>
        <p:xfrm>
          <a:off x="1112230" y="2606878"/>
          <a:ext cx="1561816" cy="10256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13744"/>
                <a:gridCol w="648072"/>
              </a:tblGrid>
              <a:tr h="65485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% of germin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llen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umbe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8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86</a:t>
                      </a:r>
                      <a:endParaRPr lang="en-US" sz="10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4350274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5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5" name="Rectangle 4"/>
          <p:cNvSpPr/>
          <p:nvPr/>
        </p:nvSpPr>
        <p:spPr>
          <a:xfrm>
            <a:off x="385821" y="755576"/>
            <a:ext cx="5995507" cy="14484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5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mpatible pollen germination and pollen tube growth in high humidity conditions. 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tigma (green fluorescence) was pollinated with compatible pollen (blue fluorescence) and incubated in high humidity conditions. A Z-stack was taken every minute after pollen deposition. Images were processed with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image J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o generate a Z-projection at each time poi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struct the video. Indicated time corresponds to time after pollen deposition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Video starts from pollen germination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Bar 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45979489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6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3" name="Rectangle 2"/>
          <p:cNvSpPr/>
          <p:nvPr/>
        </p:nvSpPr>
        <p:spPr>
          <a:xfrm>
            <a:off x="242949" y="827584"/>
            <a:ext cx="6199298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6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Behavior of incompatible pollen in high humidity conditions . (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)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Features of incompatible pollination in high humidity conditions. 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marker stigma was pollinated with incompatible pollen and incubated in high humidity conditions for 40 minutes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ou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depende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experiments. (B)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ctin (green fluorescence) rarely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ocalized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 stigmatic cells in contact with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d-fluorescent germinated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en grains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only one visible actin focalization: white arrow head). Image is a singl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focal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ection,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40 minutes after pollen deposition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C) Pollen tubes have an enlarged extremity. </a:t>
            </a:r>
            <a:r>
              <a:rPr lang="en-US" sz="1000" dirty="0" smtClean="0"/>
              <a:t>Images </a:t>
            </a:r>
            <a:r>
              <a:rPr lang="en-US" sz="1000" dirty="0"/>
              <a:t>are Z-projections.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Ba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= 50 </a:t>
            </a:r>
            <a:r>
              <a:rPr lang="en-US" sz="1000" dirty="0" smtClean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9" name="Picture 2" descr="Z:\pollination Group\frédérique\Article\suivi croissance tube\film  pollen incompatibles\image 40 mn\vue ensemble incompatible-Zproject5slides.tif (RGB)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1025" y="4479644"/>
            <a:ext cx="3168352" cy="375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ZoneTexte 12"/>
          <p:cNvSpPr txBox="1"/>
          <p:nvPr/>
        </p:nvSpPr>
        <p:spPr>
          <a:xfrm>
            <a:off x="1628800" y="435653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sp>
        <p:nvSpPr>
          <p:cNvPr id="14" name="Triangle isocèle 13"/>
          <p:cNvSpPr/>
          <p:nvPr/>
        </p:nvSpPr>
        <p:spPr>
          <a:xfrm rot="9253336">
            <a:off x="2740163" y="6069539"/>
            <a:ext cx="62923" cy="70361"/>
          </a:xfrm>
          <a:prstGeom prst="triangle">
            <a:avLst>
              <a:gd name="adj" fmla="val 52175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ZoneTexte 10"/>
          <p:cNvSpPr txBox="1"/>
          <p:nvPr/>
        </p:nvSpPr>
        <p:spPr>
          <a:xfrm>
            <a:off x="854013" y="2847132"/>
            <a:ext cx="253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graphicFrame>
        <p:nvGraphicFramePr>
          <p:cNvPr id="15" name="Tableau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6881298"/>
              </p:ext>
            </p:extLst>
          </p:nvPr>
        </p:nvGraphicFramePr>
        <p:xfrm>
          <a:off x="2780928" y="2970242"/>
          <a:ext cx="3233883" cy="10256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4708"/>
                <a:gridCol w="504056"/>
                <a:gridCol w="1107047"/>
                <a:gridCol w="648072"/>
              </a:tblGrid>
              <a:tr h="654854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rmination time (min)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M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% of papilla exhibiting actin focaliz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llen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umber</a:t>
                      </a:r>
                    </a:p>
                    <a:p>
                      <a:pPr algn="ctr"/>
                      <a:endParaRPr lang="en-US" sz="1000" b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.87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8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3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6</a:t>
                      </a:r>
                      <a:endParaRPr lang="en-US" sz="10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" name="Tableau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3241987"/>
              </p:ext>
            </p:extLst>
          </p:nvPr>
        </p:nvGraphicFramePr>
        <p:xfrm>
          <a:off x="1112230" y="2970242"/>
          <a:ext cx="1561816" cy="102569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13744"/>
                <a:gridCol w="648072"/>
              </a:tblGrid>
              <a:tr h="65485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% of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rmin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llen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ysClr val="windowText" lastClr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umbe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chemeClr val="tx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5</a:t>
                      </a:r>
                      <a:endParaRPr lang="en-US" sz="1000" dirty="0">
                        <a:solidFill>
                          <a:schemeClr val="tx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14</a:t>
                      </a:r>
                      <a:endParaRPr lang="en-US" sz="10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0728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24374" y="282878"/>
            <a:ext cx="2268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protocol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</p:txBody>
      </p:sp>
      <p:sp>
        <p:nvSpPr>
          <p:cNvPr id="3" name="Rectangle 2"/>
          <p:cNvSpPr/>
          <p:nvPr/>
        </p:nvSpPr>
        <p:spPr>
          <a:xfrm>
            <a:off x="309499" y="562961"/>
            <a:ext cx="6215845" cy="67579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r>
              <a:rPr lang="en-US" sz="10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CR14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gene cloning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enomic sequence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3,620 kb) was amplified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ith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pecific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ttB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containing primers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5’GGGGACAAGTTTGTACAAAAAAGCAGGCTACCATGAGAGGTGTAATACCAAAGTACC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’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5’GGGGACCACTTTGTACAAGAAAGCTGGGTTTACCGAGGTTCCACTTCCGTGGTGG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’) and subsequently inserted by BP recombination into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Don207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lasmid. A fragment of 4,081 kb containing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ene was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mplified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using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ttB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containing primer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5’GGGGACAAGTTTGTACAAAAAAGCAGGCTCGGGTAGCTCAACCTAGCTAAG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’ and 5’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CACTTTGTACAAGAAAGCTGGG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ATGATCACCAAAGACAAGATCC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’). This fragment was subsequently inserted by BP recombination into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DONR-Zeo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lasmid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</a:p>
          <a:p>
            <a:pPr>
              <a:lnSpc>
                <a:spcPct val="150000"/>
              </a:lnSpc>
            </a:pPr>
            <a:endParaRPr lang="en-US" sz="1000" dirty="0" smtClean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lasmid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construction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We used Gateway® vectors (Life Technologies, USA; </a:t>
            </a:r>
            <a:r>
              <a:rPr lang="en-US" sz="1000" u="sng" dirty="0">
                <a:latin typeface="Helvetica" panose="020B0604020202020204" pitchFamily="34" charset="0"/>
                <a:cs typeface="Helvetica" panose="020B0604020202020204" pitchFamily="34" charset="0"/>
                <a:hlinkClick r:id="rId2"/>
              </a:rPr>
              <a:t>http://www.thermofisher.com/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Karini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et al. 2002) for expression of transgenes in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thaliana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h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DNA fragment containing the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Brassica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oleracea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LR1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tigma specific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romoter (1.5 kb upstream of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LR1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tart codon, Hackett et al. 1996; Fobis-Loisy et al. 2007) was inserted into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DONP4-P1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lasmid (Durand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et al.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2014). Two pollen specific promoters were used, either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LAT52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from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popersicum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esculentu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Twell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et al., 1989;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Rotman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et al. 2003) or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ACT11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from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thalian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Huang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et al.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997;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Rotman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et al. 2005), which were inserted by recombination into the plasmi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DONP4-P1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Coding sequence (CDS) of TURQUOISE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TURQ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),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or RFP proteins were introduc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DONP2R-P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+Stop). The sequence encoding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TI6b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Cutler et al., 2000) was amplified and inserted i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Don207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lasmid. The entry clone containing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ifeAc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eptide fused to VENUS was provided by Takashi Ueda (Era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et al.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2009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).</a:t>
            </a:r>
          </a:p>
          <a:p>
            <a:pPr>
              <a:lnSpc>
                <a:spcPct val="150000"/>
              </a:lnSpc>
            </a:pP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Expression vectors were produced by three fragment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recombination.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LR1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romoter, the genomic sequenc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nd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3’moc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equence were insert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K7m34GW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destination vectors. The genomic sequenc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(including promoter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3’UT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regions),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5’moc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equence and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3’moc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equence were insert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B7m34GW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LR1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romoter,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ifeActin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3’moc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equence were insert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B7m34GW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).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AT52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romoter, the TURQUOISE CDS (+stop) and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3’moc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equence were insert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K7m34GW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CT11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romoter, the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R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CDS (+stop) and 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3’moc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equence were insert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K7m34GW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LR1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romoter,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TI6b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equence and the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DS (+stop) were inserted in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B7m34GW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6875912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24374" y="282878"/>
            <a:ext cx="2556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endParaRPr 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404664" y="786640"/>
            <a:ext cx="5976664" cy="5254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L/W ratio of incompatible pollen in high humidity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nditions,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10 minutes after pollen deposition. Highlighted in grey, pollen grains with L/W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ati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&lt; 1.4 (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21/46 = 46%).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0069465"/>
              </p:ext>
            </p:extLst>
          </p:nvPr>
        </p:nvGraphicFramePr>
        <p:xfrm>
          <a:off x="1916832" y="1640720"/>
          <a:ext cx="2952328" cy="68683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250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69982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636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llen numb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u="none" strike="noStrike" dirty="0" smtClean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/W ratio at </a:t>
                      </a:r>
                      <a:r>
                        <a:rPr lang="da-DK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 min</a:t>
                      </a:r>
                      <a:endParaRPr lang="da-DK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968085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7125307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1829328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370480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7061118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94456443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7653478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9184100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9580318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6383668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6640548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1520236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6253056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008441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72128174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556644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0921550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260783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59456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0503678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1933399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642633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388195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7955352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19278996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3805774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320691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67544396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7648886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4764397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88295936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2383665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550092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3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14763995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4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679528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337915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6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0760578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7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2750352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8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889387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9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5766621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40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0232558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41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4198113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42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35887611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43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0583700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44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2308075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45"/>
                  </a:ext>
                </a:extLst>
              </a:tr>
              <a:tr h="1283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48984329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6419" marR="6419" marT="641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043962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6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4" name="Rectangle 3"/>
          <p:cNvSpPr/>
          <p:nvPr/>
        </p:nvSpPr>
        <p:spPr>
          <a:xfrm>
            <a:off x="394031" y="755576"/>
            <a:ext cx="6192688" cy="14484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6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compatible pollen germination and pollen tube growth in high humidity conditions. 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tigma (green fluorescence) was pollinated with incompatible pollen (red fluorescence) and incubated in high humidity conditions. A Z-stack was taken every minute after pollen deposition. Images were processed with image J to generate a Z-projection at each time poi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struct the video. Indicated time corresponds to time after pollen deposition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Video starts from polle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ermination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Bar 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258386875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7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2" name="Rectangle 1"/>
          <p:cNvSpPr/>
          <p:nvPr/>
        </p:nvSpPr>
        <p:spPr>
          <a:xfrm>
            <a:off x="242949" y="827584"/>
            <a:ext cx="6199298" cy="12464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7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FM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64 labelling of stigmatic cells. Stigmas were incubated i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FM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64 and imaged under confocal microscopy (red fluorescence)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Images are singl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focal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ections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(A-B) FM4-64 remains at the surface of the stigmatic cells as deduced from its localization above the actin marker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A) and the </a:t>
            </a:r>
            <a:r>
              <a:rPr lang="en-US" sz="10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LTI6b:GFP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marker (B)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known to label plasma membrane (PM) and endocytic compartments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ec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)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a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=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</a:t>
            </a:r>
          </a:p>
        </p:txBody>
      </p:sp>
      <p:grpSp>
        <p:nvGrpSpPr>
          <p:cNvPr id="36" name="Groupe 35"/>
          <p:cNvGrpSpPr/>
          <p:nvPr/>
        </p:nvGrpSpPr>
        <p:grpSpPr>
          <a:xfrm>
            <a:off x="897921" y="2431417"/>
            <a:ext cx="4810339" cy="4732871"/>
            <a:chOff x="748647" y="1135273"/>
            <a:chExt cx="4810339" cy="4732871"/>
          </a:xfrm>
        </p:grpSpPr>
        <p:pic>
          <p:nvPicPr>
            <p:cNvPr id="37" name="Picture 2" descr="Z:\pollination Group\frédérique\Article\hydratation forcée FM4 64\images\FM464 labelling_1_green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912" b="13260"/>
            <a:stretch/>
          </p:blipFill>
          <p:spPr bwMode="auto">
            <a:xfrm>
              <a:off x="1047403" y="1355652"/>
              <a:ext cx="1476375" cy="20919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9" name="Picture 3" descr="Z:\pollination Group\frédérique\Article\hydratation forcée FM4 64\images\FM464 labelling_1_merge.tif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912" b="13260"/>
            <a:stretch/>
          </p:blipFill>
          <p:spPr bwMode="auto">
            <a:xfrm>
              <a:off x="4082102" y="1355651"/>
              <a:ext cx="1476375" cy="20919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0" name="Picture 4" descr="Z:\pollination Group\frédérique\Article\hydratation forcée FM4 64\images\FM464 labelling_1_red.ti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912" b="13260"/>
            <a:stretch/>
          </p:blipFill>
          <p:spPr bwMode="auto">
            <a:xfrm>
              <a:off x="2564904" y="1355651"/>
              <a:ext cx="1476375" cy="20919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4" name="ZoneTexte 43"/>
            <p:cNvSpPr txBox="1"/>
            <p:nvPr/>
          </p:nvSpPr>
          <p:spPr>
            <a:xfrm>
              <a:off x="1441641" y="1135273"/>
              <a:ext cx="7441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Act:venus</a:t>
              </a:r>
              <a:endParaRPr lang="en-US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3020000" y="1135273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M4</a:t>
              </a: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-64</a:t>
              </a: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4531768" y="1135273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merge</a:t>
              </a:r>
            </a:p>
          </p:txBody>
        </p:sp>
        <p:cxnSp>
          <p:nvCxnSpPr>
            <p:cNvPr id="52" name="Connecteur droit 51"/>
            <p:cNvCxnSpPr/>
            <p:nvPr/>
          </p:nvCxnSpPr>
          <p:spPr>
            <a:xfrm>
              <a:off x="1981958" y="3366430"/>
              <a:ext cx="496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52"/>
            <p:cNvCxnSpPr/>
            <p:nvPr/>
          </p:nvCxnSpPr>
          <p:spPr>
            <a:xfrm>
              <a:off x="5016712" y="3366430"/>
              <a:ext cx="496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53"/>
            <p:cNvCxnSpPr/>
            <p:nvPr/>
          </p:nvCxnSpPr>
          <p:spPr>
            <a:xfrm>
              <a:off x="3501008" y="3366430"/>
              <a:ext cx="496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ZoneTexte 54"/>
            <p:cNvSpPr txBox="1"/>
            <p:nvPr/>
          </p:nvSpPr>
          <p:spPr>
            <a:xfrm>
              <a:off x="764839" y="1171207"/>
              <a:ext cx="2534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A</a:t>
              </a: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748647" y="3644053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  <p:pic>
          <p:nvPicPr>
            <p:cNvPr id="57" name="Picture 2" descr="D:\isabelle\backup$\confocal\Zeiss 800\2016\11-export\Lti-FM labelling-1red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878" b="4726"/>
            <a:stretch/>
          </p:blipFill>
          <p:spPr bwMode="auto">
            <a:xfrm>
              <a:off x="2564904" y="3745043"/>
              <a:ext cx="1476375" cy="21231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8" name="Picture 3" descr="D:\isabelle\backup$\confocal\Zeiss 800\2016\11-export\Lti-FM labelling-1green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878" b="4726"/>
            <a:stretch/>
          </p:blipFill>
          <p:spPr bwMode="auto">
            <a:xfrm>
              <a:off x="1047403" y="3745043"/>
              <a:ext cx="1476375" cy="21231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9" name="Picture 4" descr="D:\isabelle\backup$\confocal\Zeiss 800\2016\11-export\Lti-FM labelling-1merge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848" b="4726"/>
            <a:stretch/>
          </p:blipFill>
          <p:spPr bwMode="auto">
            <a:xfrm>
              <a:off x="4082102" y="3745043"/>
              <a:ext cx="1476884" cy="21231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0" name="Connecteur droit 59"/>
            <p:cNvCxnSpPr/>
            <p:nvPr/>
          </p:nvCxnSpPr>
          <p:spPr>
            <a:xfrm>
              <a:off x="1992159" y="5759177"/>
              <a:ext cx="4716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/>
            <p:cNvCxnSpPr/>
            <p:nvPr/>
          </p:nvCxnSpPr>
          <p:spPr>
            <a:xfrm>
              <a:off x="3513608" y="5754940"/>
              <a:ext cx="4716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cteur droit 61"/>
            <p:cNvCxnSpPr/>
            <p:nvPr/>
          </p:nvCxnSpPr>
          <p:spPr>
            <a:xfrm>
              <a:off x="5039165" y="5759177"/>
              <a:ext cx="4716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ZoneTexte 62"/>
            <p:cNvSpPr txBox="1"/>
            <p:nvPr/>
          </p:nvSpPr>
          <p:spPr>
            <a:xfrm>
              <a:off x="1302124" y="3542365"/>
              <a:ext cx="8082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TI6b:GFP</a:t>
              </a:r>
              <a:endParaRPr lang="en-US" sz="1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3058697" y="3542365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M4</a:t>
              </a:r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-64</a:t>
              </a: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4570465" y="3542365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merge</a:t>
              </a:r>
            </a:p>
          </p:txBody>
        </p:sp>
        <p:cxnSp>
          <p:nvCxnSpPr>
            <p:cNvPr id="66" name="Connecteur droit avec flèche 65"/>
            <p:cNvCxnSpPr/>
            <p:nvPr/>
          </p:nvCxnSpPr>
          <p:spPr>
            <a:xfrm flipH="1" flipV="1">
              <a:off x="5025194" y="4528455"/>
              <a:ext cx="204006" cy="259569"/>
            </a:xfrm>
            <a:prstGeom prst="straightConnector1">
              <a:avLst/>
            </a:prstGeom>
            <a:ln>
              <a:solidFill>
                <a:srgbClr val="33CC33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/>
            <p:nvPr/>
          </p:nvSpPr>
          <p:spPr>
            <a:xfrm>
              <a:off x="5141022" y="4730531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rgbClr val="33CC33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PM</a:t>
              </a:r>
            </a:p>
          </p:txBody>
        </p:sp>
        <p:cxnSp>
          <p:nvCxnSpPr>
            <p:cNvPr id="68" name="Connecteur droit avec flèche 67"/>
            <p:cNvCxnSpPr/>
            <p:nvPr/>
          </p:nvCxnSpPr>
          <p:spPr>
            <a:xfrm flipH="1">
              <a:off x="5016713" y="4139952"/>
              <a:ext cx="51000" cy="32488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ZoneTexte 68"/>
            <p:cNvSpPr txBox="1"/>
            <p:nvPr/>
          </p:nvSpPr>
          <p:spPr>
            <a:xfrm>
              <a:off x="4919152" y="3947152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FM4</a:t>
              </a:r>
              <a:r>
                <a:rPr lang="en-US" sz="900" dirty="0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-64</a:t>
              </a:r>
            </a:p>
          </p:txBody>
        </p:sp>
        <p:cxnSp>
          <p:nvCxnSpPr>
            <p:cNvPr id="70" name="Connecteur droit avec flèche 69"/>
            <p:cNvCxnSpPr/>
            <p:nvPr/>
          </p:nvCxnSpPr>
          <p:spPr>
            <a:xfrm flipV="1">
              <a:off x="4440716" y="4162372"/>
              <a:ext cx="0" cy="259568"/>
            </a:xfrm>
            <a:prstGeom prst="straightConnector1">
              <a:avLst/>
            </a:prstGeom>
            <a:ln>
              <a:solidFill>
                <a:srgbClr val="33CC33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>
              <a:off x="4326360" y="4372420"/>
              <a:ext cx="3064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rgbClr val="33CC33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c</a:t>
              </a:r>
              <a:endParaRPr lang="en-US" sz="900" dirty="0">
                <a:solidFill>
                  <a:srgbClr val="33CC33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72" name="Connecteur droit avec flèche 71"/>
            <p:cNvCxnSpPr/>
            <p:nvPr/>
          </p:nvCxnSpPr>
          <p:spPr>
            <a:xfrm flipH="1" flipV="1">
              <a:off x="4205661" y="4327461"/>
              <a:ext cx="222047" cy="99317"/>
            </a:xfrm>
            <a:prstGeom prst="straightConnector1">
              <a:avLst/>
            </a:prstGeom>
            <a:ln>
              <a:solidFill>
                <a:srgbClr val="33CC33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cteur droit avec flèche 72"/>
            <p:cNvCxnSpPr/>
            <p:nvPr/>
          </p:nvCxnSpPr>
          <p:spPr>
            <a:xfrm flipH="1">
              <a:off x="4423014" y="2555802"/>
              <a:ext cx="230122" cy="119624"/>
            </a:xfrm>
            <a:prstGeom prst="straightConnector1">
              <a:avLst/>
            </a:prstGeom>
            <a:ln>
              <a:solidFill>
                <a:srgbClr val="33CC33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ZoneTexte 73"/>
            <p:cNvSpPr txBox="1"/>
            <p:nvPr/>
          </p:nvSpPr>
          <p:spPr>
            <a:xfrm>
              <a:off x="4609844" y="2422101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rgbClr val="33CC33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ctin</a:t>
              </a:r>
            </a:p>
          </p:txBody>
        </p:sp>
        <p:cxnSp>
          <p:nvCxnSpPr>
            <p:cNvPr id="75" name="Connecteur droit avec flèche 74"/>
            <p:cNvCxnSpPr/>
            <p:nvPr/>
          </p:nvCxnSpPr>
          <p:spPr>
            <a:xfrm flipV="1">
              <a:off x="4309242" y="2870684"/>
              <a:ext cx="91062" cy="202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ZoneTexte 75"/>
            <p:cNvSpPr txBox="1"/>
            <p:nvPr/>
          </p:nvSpPr>
          <p:spPr>
            <a:xfrm>
              <a:off x="4054806" y="3025712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FM4</a:t>
              </a:r>
              <a:r>
                <a:rPr lang="en-US" sz="900" dirty="0">
                  <a:solidFill>
                    <a:srgbClr val="FF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-6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75169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96850" y="185299"/>
            <a:ext cx="6048672" cy="19104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Plant transformation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rabidopsis transgenic plants were generated using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grobacteriu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tumefacien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mediated transformation according to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ogemann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et al.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ogemann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et al.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2006)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construct was</a:t>
            </a:r>
          </a:p>
          <a:p>
            <a:pPr>
              <a:lnSpc>
                <a:spcPct val="150000"/>
              </a:lnSpc>
            </a:pP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introduced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 Col-0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AT52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TURQ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constructs were introduced i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construct was introduced in the selected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line #10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ACT11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-R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construct was introduced in the selected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line #4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TI6b:G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was introduced in Col-0. For all transformations, unique insertion lines homozygous for the transgene were selected by segregation on antibiotic containing medium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</a:p>
        </p:txBody>
      </p:sp>
      <p:sp>
        <p:nvSpPr>
          <p:cNvPr id="7" name="Rectangle 6"/>
          <p:cNvSpPr/>
          <p:nvPr/>
        </p:nvSpPr>
        <p:spPr>
          <a:xfrm>
            <a:off x="199273" y="2339752"/>
            <a:ext cx="6408712" cy="60654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References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Cutler SR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Ehrhardt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DW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Griffitts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JS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, Somerville C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0. Random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::cDNA fusions enable visualization of subcellular structures in cells of Arabidopsis at a high frequency. Proceedings of the National Academy of Sciences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97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3718–3723.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Durand E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Meheust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R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oucaze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M, </a:t>
            </a:r>
            <a:r>
              <a:rPr lang="en-US" sz="10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et al.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2014. Dominance hierarchy arising from the evolution of a complex small RNA regulatory network. </a:t>
            </a:r>
            <a:r>
              <a:rPr lang="es-ES_tradnl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Science</a:t>
            </a:r>
            <a:r>
              <a:rPr lang="es-ES_tradnl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346</a:t>
            </a:r>
            <a:r>
              <a:rPr lang="es-ES_tradnl" sz="1000" dirty="0">
                <a:latin typeface="Helvetica" panose="020B0604020202020204" pitchFamily="34" charset="0"/>
                <a:cs typeface="Helvetica" panose="020B0604020202020204" pitchFamily="34" charset="0"/>
              </a:rPr>
              <a:t>, 1200–1205.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Era A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Tominaga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M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Ebine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K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Awai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C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aito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C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Ishizaki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K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Yamato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T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ohchi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T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akano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A, </a:t>
            </a:r>
            <a:r>
              <a:rPr lang="es-ES_tradnl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Ueda</a:t>
            </a:r>
            <a:r>
              <a:rPr lang="es-ES_tradnl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T</a:t>
            </a:r>
            <a:r>
              <a:rPr lang="es-ES_tradnl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9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pplication of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ifeac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Reveals F-Actin Dynamics in Arabidopsis thaliana and the Liverwort,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Marchanti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morph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Plant and Cell Physiology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50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1041–1048.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Fobis-Loisy I, Chambrier P, Gaude 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7. Genetic transformation of Arabidopsis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: specific expression of the green fluorescent protein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) in pistil tissues. Plant Cell Reports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26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745–753.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Hackett RM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Cadwallader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G, Franklin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FCH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1996. Functional analysis of a Brassica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olerace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SLR1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ene promoter. Plant physiology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112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1601–1607.</a:t>
            </a:r>
          </a:p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Huang S, An Y-Q, McDowell JM, McKinney EC, Meagher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RB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1997. The Arabidopsis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11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ctin gene is strongly expressed in tissues of the emerging inflorescence, pollen, and developing ovules. Plant molecular biology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3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125–139.</a:t>
            </a:r>
          </a:p>
          <a:p>
            <a:pPr>
              <a:lnSpc>
                <a:spcPct val="150000"/>
              </a:lnSpc>
            </a:pP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arimi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M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Inzé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D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Depicker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2. GATEWAY vectors for Agrobacterium-mediated plant transformation. Trends in Plant Science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7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193–195.</a:t>
            </a:r>
          </a:p>
          <a:p>
            <a:pPr>
              <a:lnSpc>
                <a:spcPct val="150000"/>
              </a:lnSpc>
            </a:pP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Logemann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E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Birkenbihl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RP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Ülker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B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omssich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IE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6. An improved method for preparing Agrobacterium cells that simplifies the Arabidopsis transformation protocol. Plant Methods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16.</a:t>
            </a:r>
          </a:p>
          <a:p>
            <a:pPr>
              <a:lnSpc>
                <a:spcPct val="150000"/>
              </a:lnSpc>
            </a:pP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Rotman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N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Durbarry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A, Wardle A, Yang WC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Chaboud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A, Faure J-E, Berger F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Twell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D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5. A novel class of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MYB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factors controls sperm-cell formation in plants. Current Biology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15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244–248.</a:t>
            </a:r>
          </a:p>
          <a:p>
            <a:pPr>
              <a:lnSpc>
                <a:spcPct val="150000"/>
              </a:lnSpc>
            </a:pP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Rotman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N, Rozier F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Boavida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L, Dumas C, Berger F, Faure J-E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3. Female control of male gamete delivery during fertilization in Arabidopsis thaliana. Current Biology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1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432–436.</a:t>
            </a:r>
          </a:p>
          <a:p>
            <a:pPr>
              <a:lnSpc>
                <a:spcPct val="150000"/>
              </a:lnSpc>
            </a:pP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Twell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D, Wing R, Yamaguchi J, McCormick 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1989. Isolation and expression of an anther-specific gene from tomato. Molecular and General Genetics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MGG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217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240–245.</a:t>
            </a:r>
          </a:p>
        </p:txBody>
      </p:sp>
    </p:spTree>
    <p:extLst>
      <p:ext uri="{BB962C8B-B14F-4D97-AF65-F5344CB8AC3E}">
        <p14:creationId xmlns:p14="http://schemas.microsoft.com/office/powerpoint/2010/main" val="35784426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637689"/>
            <a:ext cx="6048672" cy="4478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Reverse transcription and Quantitative real-time PCR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hirty stigmas from stage 13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14E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thalian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flower buds or twenty stigmas from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buds just befor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nthesi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were dissected and total RNA was extracted with the Arcturus®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icoPure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® RNA isolation kit (Life Technologies). 265 ng of total RNA were reverse-transcribed with random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hexanucleotide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RevertAid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n-US" sz="1000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200U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/µL;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Thermo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cientific) and subjected to quantitative real-time PCR with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pecific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rimers and primers within the </a:t>
            </a:r>
            <a:r>
              <a:rPr lang="en-US" sz="10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CTIN8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gene used as an internal control. Becaus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expression level was compared between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thalian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we designed primers that amplify a region of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CTIN8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cDNA conserved between the two species (forward primer 5’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GACGGACAAGTGATCACGATC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3’ and reverse primer 5’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ATAGTTGTACCACCACTGAGCAC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3’). Amplification of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was performed with two primers located within the first exon (forward primer 5’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CCGCCAGACACATCCGGGGC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3’ and reverse primer 5’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AACCCTTCCCACCATCTTGG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3’). Absence of contaminating genomic DNA was controlled with primers located within a non coding region close to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CTIN8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ene (forward primer 5’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GCTGTGACAATGCGAAGCCCC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3’ and reverse primer 5’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CCCATTTTGGTATCTAGGG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3’). Quantitative analysis of real-time PCR results was performed using the 2</a:t>
            </a:r>
            <a:r>
              <a:rPr lang="en-US" sz="1000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  <a:r>
              <a:rPr lang="en-US" sz="1000" baseline="30000" dirty="0" err="1">
                <a:latin typeface="Helvetica" panose="020B0604020202020204" pitchFamily="34" charset="0"/>
                <a:cs typeface="Helvetica" panose="020B0604020202020204" pitchFamily="34" charset="0"/>
              </a:rPr>
              <a:t>ΔΔC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method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Schmittgen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Liva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2008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) and normalized to the </a:t>
            </a:r>
            <a:r>
              <a:rPr lang="en-US" sz="10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CTIN8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reference.</a:t>
            </a:r>
          </a:p>
          <a:p>
            <a:pPr>
              <a:lnSpc>
                <a:spcPct val="150000"/>
              </a:lnSpc>
            </a:pP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ferences</a:t>
            </a:r>
          </a:p>
          <a:p>
            <a:pPr>
              <a:lnSpc>
                <a:spcPct val="150000"/>
              </a:lnSpc>
            </a:pP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chmittgen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TD,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Livak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KJ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2008. Analyzing real-time PCR data by the comparative C(T) method. Nature Protocols 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1101–1108.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224374" y="281999"/>
            <a:ext cx="2268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protocol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57436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24374" y="282878"/>
            <a:ext cx="2268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ry protocol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3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</p:txBody>
      </p:sp>
      <p:sp>
        <p:nvSpPr>
          <p:cNvPr id="3" name="Rectangle 2"/>
          <p:cNvSpPr/>
          <p:nvPr/>
        </p:nvSpPr>
        <p:spPr>
          <a:xfrm>
            <a:off x="260648" y="612656"/>
            <a:ext cx="576064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Confocal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icroscopy </a:t>
            </a:r>
          </a:p>
          <a:p>
            <a:pPr>
              <a:lnSpc>
                <a:spcPct val="150000"/>
              </a:lnSpc>
            </a:pP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VENUS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were excited at 488 nm and fluorescence detected between 510 and 551 nm, RFP and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FM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64 were excited at 552 nm and fluorescence detected between 598 and 648 nm, TURQUOISE was excited at 448 nm and fluorescence detected between 450 and 481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nm. 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void emission spectrum overlay, image acquisition was performed with the sequential mode. Serial confocal images encompassing the entire volume of the stigma were recorded every 1 µm and every 1 or 2 minutes. Images and movies were processed with Image J software (https://imagej.nih.gov/ij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/) </a:t>
            </a:r>
          </a:p>
        </p:txBody>
      </p:sp>
    </p:spTree>
    <p:extLst>
      <p:ext uri="{BB962C8B-B14F-4D97-AF65-F5344CB8AC3E}">
        <p14:creationId xmlns:p14="http://schemas.microsoft.com/office/powerpoint/2010/main" val="41770196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45"/>
          <p:cNvSpPr/>
          <p:nvPr/>
        </p:nvSpPr>
        <p:spPr>
          <a:xfrm>
            <a:off x="212402" y="843380"/>
            <a:ext cx="6456957" cy="3987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.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transgenic plant selection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RK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SC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enes from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haplotype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S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were introduced independently into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thaliana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l-0 and C24 accessions, respectively. We determined the Self-Incompatibility (SI) phenotype of transgenic plants by pollination of stage 13-14E stigmas and aniline blue staining. (A) compatibility phenotype: numerous pollen tubes detected in the stigma and style. (B) incompatibility phenotype: less tha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v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en tubes detected in the stigma. Bar = 10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(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) SI phenotype of four and two unique insertion lines homozygous for the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transgene in Col-0 and C24 background,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spectively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inations were performed with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pollen. More than 20 pollen tubes were detected in control pollinations (Col-0 x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or C24 x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). The exact number of pollen tubes was not determined considering that above 20 pollen tubes the situation is compatible (no error bar). On average, less tha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v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en tubes were detected in stigmas of transgenic plants. (D) Quantitative real-time RT-PCR of stage 13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14E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tigmas. The level of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transcripts (with SEM based on three replicates) relative to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CTIN8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CT8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is compared between two transgenic plants in Col-0 background (#10 and  #18) and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(E) We determined the SI phenotype of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v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unique insertion lines homozygous for the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transgene i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background. Pollen of these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v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ransgenic plants was deposited on the stigma of the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line #14 (C24 background). n = number of pollinated stigmas. Pollinations were performed at the same date. Error bars indicate SEM. Dashed line indicates the threshold below which the reaction is considered as incompatible (less tha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v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en tubes per stigma). </a:t>
            </a:r>
          </a:p>
        </p:txBody>
      </p:sp>
      <p:sp>
        <p:nvSpPr>
          <p:cNvPr id="75" name="ZoneTexte 74"/>
          <p:cNvSpPr txBox="1"/>
          <p:nvPr/>
        </p:nvSpPr>
        <p:spPr>
          <a:xfrm>
            <a:off x="188640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</p:spTree>
    <p:extLst>
      <p:ext uri="{BB962C8B-B14F-4D97-AF65-F5344CB8AC3E}">
        <p14:creationId xmlns:p14="http://schemas.microsoft.com/office/powerpoint/2010/main" val="7722621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88640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 Figure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graphicFrame>
        <p:nvGraphicFramePr>
          <p:cNvPr id="3" name="Graphique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0443534"/>
              </p:ext>
            </p:extLst>
          </p:nvPr>
        </p:nvGraphicFramePr>
        <p:xfrm>
          <a:off x="2076750" y="1137530"/>
          <a:ext cx="2920692" cy="17922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ZoneTexte 3"/>
          <p:cNvSpPr txBox="1"/>
          <p:nvPr/>
        </p:nvSpPr>
        <p:spPr>
          <a:xfrm rot="18718398">
            <a:off x="3435483" y="2979363"/>
            <a:ext cx="85632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4</a:t>
            </a:r>
          </a:p>
        </p:txBody>
      </p:sp>
      <p:sp>
        <p:nvSpPr>
          <p:cNvPr id="5" name="ZoneTexte 4"/>
          <p:cNvSpPr txBox="1"/>
          <p:nvPr/>
        </p:nvSpPr>
        <p:spPr>
          <a:xfrm rot="18718398">
            <a:off x="1790082" y="2971616"/>
            <a:ext cx="8258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7</a:t>
            </a:r>
          </a:p>
        </p:txBody>
      </p:sp>
      <p:sp>
        <p:nvSpPr>
          <p:cNvPr id="6" name="ZoneTexte 5"/>
          <p:cNvSpPr txBox="1"/>
          <p:nvPr/>
        </p:nvSpPr>
        <p:spPr>
          <a:xfrm rot="18718398">
            <a:off x="2053669" y="2988301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0</a:t>
            </a:r>
          </a:p>
        </p:txBody>
      </p:sp>
      <p:sp>
        <p:nvSpPr>
          <p:cNvPr id="7" name="ZoneTexte 6"/>
          <p:cNvSpPr txBox="1"/>
          <p:nvPr/>
        </p:nvSpPr>
        <p:spPr>
          <a:xfrm rot="18718398">
            <a:off x="2418317" y="2988301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5</a:t>
            </a:r>
          </a:p>
        </p:txBody>
      </p:sp>
      <p:sp>
        <p:nvSpPr>
          <p:cNvPr id="8" name="ZoneTexte 7"/>
          <p:cNvSpPr txBox="1"/>
          <p:nvPr/>
        </p:nvSpPr>
        <p:spPr>
          <a:xfrm rot="18718398">
            <a:off x="2769224" y="2988301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8</a:t>
            </a:r>
          </a:p>
        </p:txBody>
      </p:sp>
      <p:sp>
        <p:nvSpPr>
          <p:cNvPr id="9" name="ZoneTexte 8"/>
          <p:cNvSpPr txBox="1"/>
          <p:nvPr/>
        </p:nvSpPr>
        <p:spPr>
          <a:xfrm rot="18718398">
            <a:off x="3465586" y="2825626"/>
            <a:ext cx="3674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2015229" y="26790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1962182" y="21624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1962182" y="16619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20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1962182" y="11648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30</a:t>
            </a:r>
          </a:p>
        </p:txBody>
      </p:sp>
      <p:cxnSp>
        <p:nvCxnSpPr>
          <p:cNvPr id="14" name="Connecteur droit 13"/>
          <p:cNvCxnSpPr/>
          <p:nvPr/>
        </p:nvCxnSpPr>
        <p:spPr>
          <a:xfrm>
            <a:off x="2218514" y="1117395"/>
            <a:ext cx="0" cy="16737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 rot="18718398">
            <a:off x="4486542" y="2816687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1858805" y="91864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2055185" y="904043"/>
            <a:ext cx="308289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tigma: transgenic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x Pollen: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10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14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8" t="3947" r="3498" b="8462"/>
          <a:stretch/>
        </p:blipFill>
        <p:spPr>
          <a:xfrm>
            <a:off x="870241" y="959304"/>
            <a:ext cx="867648" cy="1148718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241" y="2116942"/>
            <a:ext cx="867648" cy="1148719"/>
          </a:xfrm>
          <a:prstGeom prst="rect">
            <a:avLst/>
          </a:prstGeom>
        </p:spPr>
      </p:pic>
      <p:cxnSp>
        <p:nvCxnSpPr>
          <p:cNvPr id="20" name="Connecteur droit 19"/>
          <p:cNvCxnSpPr/>
          <p:nvPr/>
        </p:nvCxnSpPr>
        <p:spPr>
          <a:xfrm>
            <a:off x="1542215" y="2025748"/>
            <a:ext cx="169069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813091" y="92132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807714" y="209811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4197835" y="2325344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4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3876417" y="2381549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4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4531320" y="1560368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3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3533766" y="1560844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3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3207626" y="2562320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3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2881930" y="2381325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3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2230596" y="2550340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3</a:t>
            </a:r>
          </a:p>
        </p:txBody>
      </p:sp>
      <p:cxnSp>
        <p:nvCxnSpPr>
          <p:cNvPr id="31" name="Connecteur droit 30"/>
          <p:cNvCxnSpPr/>
          <p:nvPr/>
        </p:nvCxnSpPr>
        <p:spPr>
          <a:xfrm>
            <a:off x="2183263" y="2525399"/>
            <a:ext cx="2668979" cy="0"/>
          </a:xfrm>
          <a:prstGeom prst="line">
            <a:avLst/>
          </a:prstGeom>
          <a:ln w="31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 rot="16200000">
            <a:off x="1167291" y="1916969"/>
            <a:ext cx="1589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number of pollen tubes/stigma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2528165" y="2594145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3</a:t>
            </a:r>
          </a:p>
        </p:txBody>
      </p:sp>
      <p:graphicFrame>
        <p:nvGraphicFramePr>
          <p:cNvPr id="35" name="Graphique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6595199"/>
              </p:ext>
            </p:extLst>
          </p:nvPr>
        </p:nvGraphicFramePr>
        <p:xfrm>
          <a:off x="684442" y="3708074"/>
          <a:ext cx="1843717" cy="16160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6" name="ZoneTexte 35"/>
          <p:cNvSpPr txBox="1"/>
          <p:nvPr/>
        </p:nvSpPr>
        <p:spPr>
          <a:xfrm rot="18718398">
            <a:off x="512619" y="5380126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0</a:t>
            </a:r>
          </a:p>
        </p:txBody>
      </p:sp>
      <p:sp>
        <p:nvSpPr>
          <p:cNvPr id="37" name="ZoneTexte 36"/>
          <p:cNvSpPr txBox="1"/>
          <p:nvPr/>
        </p:nvSpPr>
        <p:spPr>
          <a:xfrm rot="18718398">
            <a:off x="886550" y="5380126"/>
            <a:ext cx="8755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8</a:t>
            </a:r>
          </a:p>
        </p:txBody>
      </p:sp>
      <p:sp>
        <p:nvSpPr>
          <p:cNvPr id="38" name="ZoneTexte 37"/>
          <p:cNvSpPr txBox="1"/>
          <p:nvPr/>
        </p:nvSpPr>
        <p:spPr>
          <a:xfrm rot="18718398">
            <a:off x="1990399" y="5217451"/>
            <a:ext cx="3674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ol0</a:t>
            </a:r>
          </a:p>
        </p:txBody>
      </p:sp>
      <p:sp>
        <p:nvSpPr>
          <p:cNvPr id="39" name="ZoneTexte 38"/>
          <p:cNvSpPr txBox="1"/>
          <p:nvPr/>
        </p:nvSpPr>
        <p:spPr>
          <a:xfrm rot="18718398">
            <a:off x="1364451" y="5333647"/>
            <a:ext cx="6992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n-US" sz="7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lyrata</a:t>
            </a:r>
            <a:r>
              <a:rPr lang="en-U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 S14</a:t>
            </a:r>
          </a:p>
        </p:txBody>
      </p:sp>
      <p:graphicFrame>
        <p:nvGraphicFramePr>
          <p:cNvPr id="40" name="Graphique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077877"/>
              </p:ext>
            </p:extLst>
          </p:nvPr>
        </p:nvGraphicFramePr>
        <p:xfrm>
          <a:off x="2802150" y="3714052"/>
          <a:ext cx="2213309" cy="15979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1" name="ZoneTexte 40"/>
          <p:cNvSpPr txBox="1"/>
          <p:nvPr/>
        </p:nvSpPr>
        <p:spPr>
          <a:xfrm rot="16200000">
            <a:off x="1902493" y="4349278"/>
            <a:ext cx="1589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number of pollen tubes/stigma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1008254" y="3461821"/>
            <a:ext cx="10679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Q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RTPCR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RK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 rot="18718398">
            <a:off x="4102148" y="5393088"/>
            <a:ext cx="86113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CR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11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2752451" y="50605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2693584" y="46101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2685633" y="41738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20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2692144" y="37306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30</a:t>
            </a:r>
          </a:p>
        </p:txBody>
      </p:sp>
      <p:sp>
        <p:nvSpPr>
          <p:cNvPr id="48" name="ZoneTexte 47"/>
          <p:cNvSpPr txBox="1"/>
          <p:nvPr/>
        </p:nvSpPr>
        <p:spPr>
          <a:xfrm rot="18718398">
            <a:off x="2575043" y="5355099"/>
            <a:ext cx="8114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24/SCR14 # 1</a:t>
            </a:r>
          </a:p>
        </p:txBody>
      </p:sp>
      <p:sp>
        <p:nvSpPr>
          <p:cNvPr id="49" name="ZoneTexte 48"/>
          <p:cNvSpPr txBox="1"/>
          <p:nvPr/>
        </p:nvSpPr>
        <p:spPr>
          <a:xfrm rot="18718398">
            <a:off x="2921575" y="5355099"/>
            <a:ext cx="8114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24/SCR14 # 4</a:t>
            </a:r>
          </a:p>
        </p:txBody>
      </p:sp>
      <p:sp>
        <p:nvSpPr>
          <p:cNvPr id="50" name="ZoneTexte 49"/>
          <p:cNvSpPr txBox="1"/>
          <p:nvPr/>
        </p:nvSpPr>
        <p:spPr>
          <a:xfrm rot="18718398">
            <a:off x="3326246" y="5355099"/>
            <a:ext cx="8114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24/SCR14 # 5</a:t>
            </a:r>
          </a:p>
        </p:txBody>
      </p:sp>
      <p:sp>
        <p:nvSpPr>
          <p:cNvPr id="51" name="ZoneTexte 50"/>
          <p:cNvSpPr txBox="1"/>
          <p:nvPr/>
        </p:nvSpPr>
        <p:spPr>
          <a:xfrm rot="18718398">
            <a:off x="3714535" y="5355099"/>
            <a:ext cx="8114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24/SCR14 # 8</a:t>
            </a:r>
          </a:p>
        </p:txBody>
      </p:sp>
      <p:sp>
        <p:nvSpPr>
          <p:cNvPr id="52" name="ZoneTexte 51"/>
          <p:cNvSpPr txBox="1"/>
          <p:nvPr/>
        </p:nvSpPr>
        <p:spPr>
          <a:xfrm>
            <a:off x="2739616" y="3471347"/>
            <a:ext cx="331693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Stigma: C24/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#14 x Pollen: transgenic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lSCR14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</a:p>
        </p:txBody>
      </p:sp>
      <p:sp>
        <p:nvSpPr>
          <p:cNvPr id="53" name="ZoneTexte 52"/>
          <p:cNvSpPr txBox="1"/>
          <p:nvPr/>
        </p:nvSpPr>
        <p:spPr>
          <a:xfrm>
            <a:off x="4522334" y="4893340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4</a:t>
            </a:r>
          </a:p>
        </p:txBody>
      </p:sp>
      <p:sp>
        <p:nvSpPr>
          <p:cNvPr id="54" name="ZoneTexte 53"/>
          <p:cNvSpPr txBox="1"/>
          <p:nvPr/>
        </p:nvSpPr>
        <p:spPr>
          <a:xfrm>
            <a:off x="2984139" y="4947716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5</a:t>
            </a:r>
          </a:p>
        </p:txBody>
      </p:sp>
      <p:sp>
        <p:nvSpPr>
          <p:cNvPr id="55" name="ZoneTexte 54"/>
          <p:cNvSpPr txBox="1"/>
          <p:nvPr/>
        </p:nvSpPr>
        <p:spPr>
          <a:xfrm>
            <a:off x="3750613" y="4892359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5</a:t>
            </a:r>
          </a:p>
        </p:txBody>
      </p:sp>
      <p:sp>
        <p:nvSpPr>
          <p:cNvPr id="56" name="ZoneTexte 55"/>
          <p:cNvSpPr txBox="1"/>
          <p:nvPr/>
        </p:nvSpPr>
        <p:spPr>
          <a:xfrm>
            <a:off x="4141113" y="4749947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5</a:t>
            </a:r>
          </a:p>
        </p:txBody>
      </p:sp>
      <p:sp>
        <p:nvSpPr>
          <p:cNvPr id="57" name="ZoneTexte 56"/>
          <p:cNvSpPr txBox="1"/>
          <p:nvPr/>
        </p:nvSpPr>
        <p:spPr>
          <a:xfrm>
            <a:off x="3370156" y="4941232"/>
            <a:ext cx="3369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n=4</a:t>
            </a:r>
          </a:p>
        </p:txBody>
      </p:sp>
      <p:cxnSp>
        <p:nvCxnSpPr>
          <p:cNvPr id="58" name="Connecteur droit 57"/>
          <p:cNvCxnSpPr/>
          <p:nvPr/>
        </p:nvCxnSpPr>
        <p:spPr>
          <a:xfrm>
            <a:off x="2906410" y="4950002"/>
            <a:ext cx="2057075" cy="0"/>
          </a:xfrm>
          <a:prstGeom prst="line">
            <a:avLst/>
          </a:prstGeom>
          <a:ln w="31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8"/>
          <p:cNvSpPr txBox="1"/>
          <p:nvPr/>
        </p:nvSpPr>
        <p:spPr>
          <a:xfrm>
            <a:off x="2553054" y="3461822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E</a:t>
            </a:r>
          </a:p>
        </p:txBody>
      </p:sp>
      <p:sp>
        <p:nvSpPr>
          <p:cNvPr id="60" name="ZoneTexte 59"/>
          <p:cNvSpPr txBox="1"/>
          <p:nvPr/>
        </p:nvSpPr>
        <p:spPr>
          <a:xfrm rot="16200000">
            <a:off x="-262335" y="4348901"/>
            <a:ext cx="18720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</a:t>
            </a:r>
            <a:r>
              <a:rPr lang="en-US" sz="8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lSRK14</a:t>
            </a:r>
            <a:r>
              <a:rPr lang="en-US" sz="8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800" i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ACT8</a:t>
            </a:r>
            <a:endParaRPr lang="en-US" sz="8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703085" y="346182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D </a:t>
            </a:r>
            <a:endParaRPr lang="en-US" sz="1000" dirty="0"/>
          </a:p>
        </p:txBody>
      </p:sp>
      <p:cxnSp>
        <p:nvCxnSpPr>
          <p:cNvPr id="62" name="Connecteur droit 61"/>
          <p:cNvCxnSpPr/>
          <p:nvPr/>
        </p:nvCxnSpPr>
        <p:spPr>
          <a:xfrm>
            <a:off x="2934980" y="3708041"/>
            <a:ext cx="0" cy="14670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/>
          <p:nvPr/>
        </p:nvSpPr>
        <p:spPr>
          <a:xfrm rot="18607871">
            <a:off x="3742229" y="3003076"/>
            <a:ext cx="85632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C2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SRK14</a:t>
            </a:r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 # </a:t>
            </a:r>
            <a:r>
              <a:rPr lang="en-US" sz="7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7</a:t>
            </a:r>
            <a:endParaRPr lang="en-U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06034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78777" y="755576"/>
            <a:ext cx="5858535" cy="16793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video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Dual pollination with compatible and incompatible pollen deposited on the same stigma. A stigma expressing the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marker (green fluorescence) was pollinated first with incompatible pollen (left part of the stigma, red fluorescence) and immediately after with compatible pollen (right part of the stigma, blue fluorescence). A Z-stack was taken every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w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inutes after pollen deposition. Images were processed with ImageJ to generate a Z-projection at each time poi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struct the video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dicated time corresponds to time after pollen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eposition. Bar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= 5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1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</p:spTree>
    <p:extLst>
      <p:ext uri="{BB962C8B-B14F-4D97-AF65-F5344CB8AC3E}">
        <p14:creationId xmlns:p14="http://schemas.microsoft.com/office/powerpoint/2010/main" val="19655811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42949" y="323528"/>
            <a:ext cx="29546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</a:t>
            </a:r>
            <a:r>
              <a:rPr lang="en-US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ideo </a:t>
            </a:r>
            <a:r>
              <a:rPr lang="en-US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		</a:t>
            </a:r>
          </a:p>
        </p:txBody>
      </p:sp>
      <p:sp>
        <p:nvSpPr>
          <p:cNvPr id="4" name="Rectangle 3"/>
          <p:cNvSpPr/>
          <p:nvPr/>
        </p:nvSpPr>
        <p:spPr>
          <a:xfrm>
            <a:off x="385821" y="755576"/>
            <a:ext cx="5851491" cy="12176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video </a:t>
            </a:r>
            <a:r>
              <a:rPr lang="en-US" sz="10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S2</a:t>
            </a:r>
            <a:r>
              <a:rPr lang="en-US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ctin rearrangement at the pollen contact site.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Act:Venus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tigma (green fluorescence)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as dual-pollinated and we focused on one stigmatic cell in contact with a compatible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pollen (blue fluorescence). A Z-stack was taken every minute after pollen deposition. Images were processed with Image J to generate a Z-projection at each time point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construct the video. Indicated time corresponds to time after pollen deposition. Bar = 10 </a:t>
            </a:r>
            <a:r>
              <a:rPr lang="en-US" sz="1000" dirty="0">
                <a:latin typeface="Symbol" panose="05050102010706020507" pitchFamily="18" charset="2"/>
                <a:cs typeface="Helvetica" panose="020B0604020202020204" pitchFamily="34" charset="0"/>
              </a:rPr>
              <a:t>m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39083050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19</TotalTime>
  <Words>3485</Words>
  <Application>Microsoft Office PowerPoint</Application>
  <PresentationFormat>Affichage à l'écran (4:3)</PresentationFormat>
  <Paragraphs>394</Paragraphs>
  <Slides>2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2</vt:i4>
      </vt:variant>
    </vt:vector>
  </HeadingPairs>
  <TitlesOfParts>
    <vt:vector size="23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fobis</dc:creator>
  <cp:lastModifiedBy>ifobis</cp:lastModifiedBy>
  <cp:revision>691</cp:revision>
  <cp:lastPrinted>2019-09-03T12:47:02Z</cp:lastPrinted>
  <dcterms:created xsi:type="dcterms:W3CDTF">2018-03-19T12:36:10Z</dcterms:created>
  <dcterms:modified xsi:type="dcterms:W3CDTF">2019-12-05T19:22:24Z</dcterms:modified>
</cp:coreProperties>
</file>